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notesMasterIdLst>
    <p:notesMasterId r:id="rId8"/>
  </p:notesMasterIdLst>
  <p:sldIdLst>
    <p:sldId id="423" r:id="rId3"/>
    <p:sldId id="424" r:id="rId4"/>
    <p:sldId id="425" r:id="rId5"/>
    <p:sldId id="426" r:id="rId6"/>
    <p:sldId id="42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1" d="100"/>
          <a:sy n="91" d="100"/>
        </p:scale>
        <p:origin x="32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4DAC87-3994-43C9-B2D0-F476B4F1D489}" type="datetimeFigureOut">
              <a:t>5/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E732FD-A580-4FA7-BF73-D3E4CF0B3D3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2279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Need to look back over – finding these to be not the correct images for the figure of AA (Right side – unfinished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E732FD-A580-4FA7-BF73-D3E4CF0B3D35}" type="slidenum"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5897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A29B10-60CB-8FC1-7543-6B838A9DCB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7D93A4-0EA0-26AF-EA53-879A7E884D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EBA046-E2BB-0199-4EA1-76C89238E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6B485E-F197-055F-D98D-4C5FF9B77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74A013-829A-547C-3A24-EE46E07D1E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547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776C49-7E88-F461-A9FA-18CA618CCC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C7D201-EEBA-FB58-4D89-924FFB26E3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053D41-ED84-8A90-5D9A-107A6C4A1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24D118-E149-0E53-5331-7E35A2904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80B53F-0505-AB6E-A26C-6A43F8D0B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398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8643E2-C3C2-76D7-E40C-79B946A755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779F57-C3D9-E9B3-1BFE-397380980A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57D0F1-CD2A-635C-9C10-F19F5E524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627865-F631-669C-7385-10C982F93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599A5-3717-47E1-AE94-73A36169C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917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BA1897-202C-9431-D337-5261DCDD4F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381D2-60BE-0615-E72B-FCA0C16436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04815F-2DD3-8743-EA03-E1A1C3F97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D10D9C-E947-FACA-BCDD-F68BEF53F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E287F4-6606-C45A-7F18-9E965F17F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900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049B1-8702-930D-2B06-431B128CB0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FD5B3A-AABE-0AC6-29EB-05CA239701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668EB2-6E46-2AE6-9879-F3DFBD111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479F42-7D26-866C-7A20-58C7FF2B1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2BD883-FF4C-1900-1875-A94DEAED9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82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F3650-6DA9-0279-B0C8-5BA056C272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C5542B-D41A-65D6-C752-0502995E3E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9FDCCB-86AF-832F-D0B5-E232476428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D3D15F-EC72-73F5-0466-4190EB71E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6CCC69-965D-C2FE-93FB-5910F30FF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56E5A5-89F6-A8F2-BAB9-25CD26930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539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BDA98-F5C9-8195-90B1-4270460F8B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9E3F40-B2AB-ACBA-FB86-4C361A645F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720B5B-29F0-D05E-2B22-9F574CEF8B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8910305-255A-FC13-447E-C79766BC5A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98DDCA-B4F0-BACF-CD06-E5212AAFB5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1A84AF-A209-B5B7-31D0-6A8FEB758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C44853-F343-6C76-48AB-C74F40612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DF772A-035E-B9C9-B780-502B76441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845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912A7E-F49B-621E-34DE-793C84BD6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5F3CC7-736B-A0CF-3C52-40CC3BCA2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CB0238-6BB6-B481-5A5F-FFA769D5C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373DFA-F3AD-4C74-D82D-290D9336D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801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C0FCBF-0223-FA45-6856-58C36FE21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C3759B-0069-26FC-A7D3-563D41D25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7A6871-53AE-3DDD-0CC3-B9766BCBB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80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6AF06C-B3C5-E418-F7BC-7CB634E46C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982576-EDF9-2CD9-914A-15143BD650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8B95DA-6D27-D548-FEB6-6752235850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BC7C0D-7DE4-1F9C-D215-01FD57E20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A6B3EA-7B03-AB4E-5004-F89A54935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E29332-9B07-62B3-2BC9-E9FBD6F68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794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BBDFF-5619-3AB4-1F31-FF7A8A6B48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0A8E815-DABF-C93C-3D47-BD99ED0D10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290B35-309C-8AA4-B260-14FFF3EE2D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ECD405-03A6-FE27-1712-34E5A9C6D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432CEC-A087-0094-F64E-DD20BAAFD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487393-0FE4-62A4-682A-FC1444C0D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385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FC64331-8F3E-8C2C-43C9-E03B7A8327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BD7783-4976-91FB-5BA8-24A56B11B8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B2FC7E-2FC3-A804-75FC-4C402A25E1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815872-9BF4-41E5-B6BB-E86177A34B8F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A92BE6-4497-60AA-1A3B-C74F675897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148165-DD07-4541-D5E0-ECA8623B16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64175-CFBC-4AC2-BFA9-E30EC6D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68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8.png"/><Relationship Id="rId7" Type="http://schemas.microsoft.com/office/2007/relationships/hdphoto" Target="../media/hdphoto1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microsoft.com/office/2007/relationships/hdphoto" Target="../media/hdphoto3.wdp"/><Relationship Id="rId7" Type="http://schemas.openxmlformats.org/officeDocument/2006/relationships/image" Target="../media/image27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7" name="Group 196">
            <a:extLst>
              <a:ext uri="{FF2B5EF4-FFF2-40B4-BE49-F238E27FC236}">
                <a16:creationId xmlns:a16="http://schemas.microsoft.com/office/drawing/2014/main" id="{DB4ECE4C-5E04-14BF-94A5-D6DF4F7657C7}"/>
              </a:ext>
            </a:extLst>
          </p:cNvPr>
          <p:cNvGrpSpPr/>
          <p:nvPr/>
        </p:nvGrpSpPr>
        <p:grpSpPr>
          <a:xfrm>
            <a:off x="1364441" y="3032245"/>
            <a:ext cx="9189735" cy="1463679"/>
            <a:chOff x="28468" y="295605"/>
            <a:chExt cx="9189735" cy="1463679"/>
          </a:xfrm>
        </p:grpSpPr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B33290C0-4455-D183-3A37-BB76B06336C4}"/>
                </a:ext>
              </a:extLst>
            </p:cNvPr>
            <p:cNvGrpSpPr/>
            <p:nvPr/>
          </p:nvGrpSpPr>
          <p:grpSpPr>
            <a:xfrm>
              <a:off x="1269082" y="517885"/>
              <a:ext cx="4113756" cy="616196"/>
              <a:chOff x="465601" y="825590"/>
              <a:chExt cx="2160376" cy="510717"/>
            </a:xfrm>
          </p:grpSpPr>
          <p:pic>
            <p:nvPicPr>
              <p:cNvPr id="2" name="Picture 1" descr="A black and white photo of a rectangular object&#10;&#10;Description automatically generated">
                <a:extLst>
                  <a:ext uri="{FF2B5EF4-FFF2-40B4-BE49-F238E27FC236}">
                    <a16:creationId xmlns:a16="http://schemas.microsoft.com/office/drawing/2014/main" id="{10BE1240-4CE4-7317-938B-AEE3F6509A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6283" t="11364" r="13369" b="7954"/>
              <a:stretch/>
            </p:blipFill>
            <p:spPr>
              <a:xfrm>
                <a:off x="465601" y="825590"/>
                <a:ext cx="2160376" cy="510717"/>
              </a:xfrm>
              <a:prstGeom prst="rect">
                <a:avLst/>
              </a:prstGeom>
            </p:spPr>
          </p:pic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98645B9C-C6BC-6BCE-8B9B-A8EA4C189FC8}"/>
                  </a:ext>
                </a:extLst>
              </p:cNvPr>
              <p:cNvSpPr/>
              <p:nvPr/>
            </p:nvSpPr>
            <p:spPr>
              <a:xfrm>
                <a:off x="483123" y="836628"/>
                <a:ext cx="2128886" cy="286731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DE8A6489-D599-6CBD-3705-DDAA87C7034E}"/>
                </a:ext>
              </a:extLst>
            </p:cNvPr>
            <p:cNvGrpSpPr/>
            <p:nvPr/>
          </p:nvGrpSpPr>
          <p:grpSpPr>
            <a:xfrm>
              <a:off x="5390263" y="522911"/>
              <a:ext cx="3602486" cy="546034"/>
              <a:chOff x="2891801" y="874938"/>
              <a:chExt cx="2085815" cy="447594"/>
            </a:xfrm>
          </p:grpSpPr>
          <p:pic>
            <p:nvPicPr>
              <p:cNvPr id="6" name="Picture 5" descr="A close-up of a tube&#10;&#10;Description automatically generated">
                <a:extLst>
                  <a:ext uri="{FF2B5EF4-FFF2-40B4-BE49-F238E27FC236}">
                    <a16:creationId xmlns:a16="http://schemas.microsoft.com/office/drawing/2014/main" id="{495EC308-6ACF-2D4D-ECA1-BFD153B787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519" t="13793" r="15445" b="14942"/>
              <a:stretch/>
            </p:blipFill>
            <p:spPr>
              <a:xfrm>
                <a:off x="2891801" y="874938"/>
                <a:ext cx="2085815" cy="447594"/>
              </a:xfrm>
              <a:prstGeom prst="rect">
                <a:avLst/>
              </a:prstGeom>
            </p:spPr>
          </p:pic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C999BBF2-093D-94EA-BFA5-8A27272DBC4D}"/>
                  </a:ext>
                </a:extLst>
              </p:cNvPr>
              <p:cNvSpPr/>
              <p:nvPr/>
            </p:nvSpPr>
            <p:spPr>
              <a:xfrm>
                <a:off x="2905375" y="884067"/>
                <a:ext cx="2063600" cy="281922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B0A2B31B-012D-E3AB-AEE5-8B51DBDC841E}"/>
                </a:ext>
              </a:extLst>
            </p:cNvPr>
            <p:cNvGrpSpPr/>
            <p:nvPr/>
          </p:nvGrpSpPr>
          <p:grpSpPr>
            <a:xfrm>
              <a:off x="1270053" y="1194322"/>
              <a:ext cx="4113558" cy="545996"/>
              <a:chOff x="685773" y="2038123"/>
              <a:chExt cx="2144467" cy="458999"/>
            </a:xfrm>
          </p:grpSpPr>
          <p:pic>
            <p:nvPicPr>
              <p:cNvPr id="4" name="Picture 3" descr="A close-up of a dna test&#10;&#10;Description automatically generated">
                <a:extLst>
                  <a:ext uri="{FF2B5EF4-FFF2-40B4-BE49-F238E27FC236}">
                    <a16:creationId xmlns:a16="http://schemas.microsoft.com/office/drawing/2014/main" id="{18E211AF-0711-EB5C-3832-B2D691EF0F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8257" t="11932" r="14286" b="17045"/>
              <a:stretch/>
            </p:blipFill>
            <p:spPr>
              <a:xfrm>
                <a:off x="685773" y="2038123"/>
                <a:ext cx="2144467" cy="458999"/>
              </a:xfrm>
              <a:prstGeom prst="rect">
                <a:avLst/>
              </a:prstGeom>
            </p:spPr>
          </p:pic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6C5364AA-6054-1083-9C28-FEC6232392E3}"/>
                  </a:ext>
                </a:extLst>
              </p:cNvPr>
              <p:cNvSpPr/>
              <p:nvPr/>
            </p:nvSpPr>
            <p:spPr>
              <a:xfrm>
                <a:off x="703082" y="2038545"/>
                <a:ext cx="2109247" cy="286731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D8B5CD15-76BA-493A-1461-DA1C89838D63}"/>
                </a:ext>
              </a:extLst>
            </p:cNvPr>
            <p:cNvGrpSpPr/>
            <p:nvPr/>
          </p:nvGrpSpPr>
          <p:grpSpPr>
            <a:xfrm>
              <a:off x="5392591" y="1181896"/>
              <a:ext cx="3601334" cy="577388"/>
              <a:chOff x="3210162" y="2037684"/>
              <a:chExt cx="2084663" cy="460213"/>
            </a:xfrm>
          </p:grpSpPr>
          <p:pic>
            <p:nvPicPr>
              <p:cNvPr id="7" name="Picture 6" descr="A close-up of a dna test&#10;&#10;Description automatically generated">
                <a:extLst>
                  <a:ext uri="{FF2B5EF4-FFF2-40B4-BE49-F238E27FC236}">
                    <a16:creationId xmlns:a16="http://schemas.microsoft.com/office/drawing/2014/main" id="{22D85BBA-75AD-C2AF-252C-2D3A1F985A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519" t="12429" r="16776" b="15012"/>
              <a:stretch/>
            </p:blipFill>
            <p:spPr>
              <a:xfrm>
                <a:off x="3210162" y="2037684"/>
                <a:ext cx="2084663" cy="460213"/>
              </a:xfrm>
              <a:prstGeom prst="rect">
                <a:avLst/>
              </a:prstGeom>
            </p:spPr>
          </p:pic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0A0B2EAC-A86F-6038-4A26-A0F9DE6586A1}"/>
                  </a:ext>
                </a:extLst>
              </p:cNvPr>
              <p:cNvSpPr/>
              <p:nvPr/>
            </p:nvSpPr>
            <p:spPr>
              <a:xfrm>
                <a:off x="3224752" y="2050328"/>
                <a:ext cx="2058186" cy="278875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D233B272-0038-60AD-3A22-07810DE93750}"/>
                </a:ext>
              </a:extLst>
            </p:cNvPr>
            <p:cNvSpPr txBox="1"/>
            <p:nvPr/>
          </p:nvSpPr>
          <p:spPr>
            <a:xfrm>
              <a:off x="105863" y="1158753"/>
              <a:ext cx="971486" cy="564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tal Protein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578C6E65-2A31-6AA1-A660-DBA974E98367}"/>
                </a:ext>
              </a:extLst>
            </p:cNvPr>
            <p:cNvSpPr txBox="1"/>
            <p:nvPr/>
          </p:nvSpPr>
          <p:spPr>
            <a:xfrm>
              <a:off x="28468" y="511892"/>
              <a:ext cx="1206184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DM16</a:t>
              </a:r>
            </a:p>
          </p:txBody>
        </p: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FC9CE5E8-04B6-B390-2B5D-63589C919FBF}"/>
                </a:ext>
              </a:extLst>
            </p:cNvPr>
            <p:cNvCxnSpPr>
              <a:cxnSpLocks/>
            </p:cNvCxnSpPr>
            <p:nvPr/>
          </p:nvCxnSpPr>
          <p:spPr>
            <a:xfrm>
              <a:off x="5869925" y="460327"/>
              <a:ext cx="144903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361A5C49-F67C-4EDC-6359-F9C851F821FF}"/>
                </a:ext>
              </a:extLst>
            </p:cNvPr>
            <p:cNvCxnSpPr>
              <a:cxnSpLocks/>
            </p:cNvCxnSpPr>
            <p:nvPr/>
          </p:nvCxnSpPr>
          <p:spPr>
            <a:xfrm>
              <a:off x="3571868" y="463020"/>
              <a:ext cx="15313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8FCF43B1-2EC0-CDEB-E92E-67A7C7BAD423}"/>
                </a:ext>
              </a:extLst>
            </p:cNvPr>
            <p:cNvCxnSpPr>
              <a:cxnSpLocks/>
            </p:cNvCxnSpPr>
            <p:nvPr/>
          </p:nvCxnSpPr>
          <p:spPr>
            <a:xfrm>
              <a:off x="1606101" y="465243"/>
              <a:ext cx="170001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0838D48B-E331-4A38-FF92-61FD2C3FA154}"/>
                </a:ext>
              </a:extLst>
            </p:cNvPr>
            <p:cNvCxnSpPr>
              <a:cxnSpLocks/>
            </p:cNvCxnSpPr>
            <p:nvPr/>
          </p:nvCxnSpPr>
          <p:spPr>
            <a:xfrm>
              <a:off x="5141446" y="462676"/>
              <a:ext cx="15683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596C09B5-1120-CD97-60E5-44002522F510}"/>
                </a:ext>
              </a:extLst>
            </p:cNvPr>
            <p:cNvSpPr txBox="1"/>
            <p:nvPr/>
          </p:nvSpPr>
          <p:spPr>
            <a:xfrm>
              <a:off x="854348" y="466489"/>
              <a:ext cx="435042" cy="28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21980574-1E5B-A2E1-94B9-22EFCAA805D4}"/>
                </a:ext>
              </a:extLst>
            </p:cNvPr>
            <p:cNvSpPr txBox="1"/>
            <p:nvPr/>
          </p:nvSpPr>
          <p:spPr>
            <a:xfrm>
              <a:off x="874469" y="298818"/>
              <a:ext cx="377021" cy="28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9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33EC4A91-3B0D-2F06-7B0D-3D5D019E57E6}"/>
                </a:ext>
              </a:extLst>
            </p:cNvPr>
            <p:cNvSpPr txBox="1"/>
            <p:nvPr/>
          </p:nvSpPr>
          <p:spPr>
            <a:xfrm>
              <a:off x="873844" y="1134404"/>
              <a:ext cx="435042" cy="28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0F389D59-A162-57F1-9164-0E99C3CDE4C2}"/>
                </a:ext>
              </a:extLst>
            </p:cNvPr>
            <p:cNvCxnSpPr>
              <a:cxnSpLocks/>
            </p:cNvCxnSpPr>
            <p:nvPr/>
          </p:nvCxnSpPr>
          <p:spPr>
            <a:xfrm>
              <a:off x="1223665" y="1463064"/>
              <a:ext cx="113799" cy="46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0274BA8B-2CE1-7854-389B-3FE4C0EDD834}"/>
                </a:ext>
              </a:extLst>
            </p:cNvPr>
            <p:cNvSpPr txBox="1"/>
            <p:nvPr/>
          </p:nvSpPr>
          <p:spPr>
            <a:xfrm>
              <a:off x="875658" y="1349428"/>
              <a:ext cx="477520" cy="28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D3A377ED-D58C-607A-54E9-628BC7281248}"/>
                </a:ext>
              </a:extLst>
            </p:cNvPr>
            <p:cNvSpPr txBox="1"/>
            <p:nvPr/>
          </p:nvSpPr>
          <p:spPr>
            <a:xfrm>
              <a:off x="855480" y="700774"/>
              <a:ext cx="435042" cy="28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21787348-EB73-0907-7398-9427D49E61BF}"/>
                </a:ext>
              </a:extLst>
            </p:cNvPr>
            <p:cNvCxnSpPr>
              <a:cxnSpLocks/>
            </p:cNvCxnSpPr>
            <p:nvPr/>
          </p:nvCxnSpPr>
          <p:spPr>
            <a:xfrm>
              <a:off x="1301619" y="465243"/>
              <a:ext cx="18809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090F9FEB-CB90-B673-AEF1-83A164FE44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91433" y="518004"/>
              <a:ext cx="0" cy="122461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2918DAF-FF49-102A-095C-BAF302B63CE3}"/>
                </a:ext>
              </a:extLst>
            </p:cNvPr>
            <p:cNvSpPr txBox="1"/>
            <p:nvPr/>
          </p:nvSpPr>
          <p:spPr>
            <a:xfrm>
              <a:off x="1177460" y="296367"/>
              <a:ext cx="42492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MW                           RT-F                                                                RT-M                      LC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33562651-231B-E233-5874-45F9D0F14B7C}"/>
                </a:ext>
              </a:extLst>
            </p:cNvPr>
            <p:cNvSpPr txBox="1"/>
            <p:nvPr/>
          </p:nvSpPr>
          <p:spPr>
            <a:xfrm>
              <a:off x="5350376" y="295605"/>
              <a:ext cx="3867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W  LC                     TN-F                                                  TN-M     </a:t>
              </a:r>
              <a:endParaRPr lang="en-US" sz="8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864F39D7-7CDE-92FF-9EF0-5D6AA5F0B017}"/>
                </a:ext>
              </a:extLst>
            </p:cNvPr>
            <p:cNvCxnSpPr>
              <a:cxnSpLocks/>
            </p:cNvCxnSpPr>
            <p:nvPr/>
          </p:nvCxnSpPr>
          <p:spPr>
            <a:xfrm>
              <a:off x="5468171" y="464288"/>
              <a:ext cx="32024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92761017-5614-065B-0167-156D0FC0C49F}"/>
                </a:ext>
              </a:extLst>
            </p:cNvPr>
            <p:cNvCxnSpPr>
              <a:cxnSpLocks/>
            </p:cNvCxnSpPr>
            <p:nvPr/>
          </p:nvCxnSpPr>
          <p:spPr>
            <a:xfrm>
              <a:off x="7412547" y="464290"/>
              <a:ext cx="144903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2A4C22CA-0829-4C01-CDC8-1BD33FAD9D71}"/>
                </a:ext>
              </a:extLst>
            </p:cNvPr>
            <p:cNvCxnSpPr>
              <a:cxnSpLocks/>
            </p:cNvCxnSpPr>
            <p:nvPr/>
          </p:nvCxnSpPr>
          <p:spPr>
            <a:xfrm>
              <a:off x="1224217" y="584385"/>
              <a:ext cx="1184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DF26BE31-A98B-3075-6230-2237344FF9D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21981" y="819691"/>
              <a:ext cx="11380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25CA7329-79BA-6979-8565-44DE3F13CE49}"/>
                </a:ext>
              </a:extLst>
            </p:cNvPr>
            <p:cNvCxnSpPr>
              <a:cxnSpLocks/>
            </p:cNvCxnSpPr>
            <p:nvPr/>
          </p:nvCxnSpPr>
          <p:spPr>
            <a:xfrm>
              <a:off x="1223277" y="1253531"/>
              <a:ext cx="11380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06E5D3DC-ED73-57BF-249D-B8F5343DA59B}"/>
              </a:ext>
            </a:extLst>
          </p:cNvPr>
          <p:cNvSpPr txBox="1"/>
          <p:nvPr/>
        </p:nvSpPr>
        <p:spPr>
          <a:xfrm>
            <a:off x="65062" y="2465972"/>
            <a:ext cx="3777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A: whole blo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FC44B9D-9F29-F72D-5ACC-1E2CBF366C7A}"/>
              </a:ext>
            </a:extLst>
          </p:cNvPr>
          <p:cNvSpPr txBox="1"/>
          <p:nvPr/>
        </p:nvSpPr>
        <p:spPr>
          <a:xfrm>
            <a:off x="73451" y="0"/>
            <a:ext cx="10865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1: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blots depicting representative images used for Figures 3A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ots for PRDM16 were cut just below 75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7975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F2ED7136-4720-AF6C-264E-5F15AA4D5AFE}"/>
              </a:ext>
            </a:extLst>
          </p:cNvPr>
          <p:cNvSpPr txBox="1"/>
          <p:nvPr/>
        </p:nvSpPr>
        <p:spPr>
          <a:xfrm>
            <a:off x="74545" y="5455194"/>
            <a:ext cx="8762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F7CFC07-2A06-7817-A825-CDE7214243BC}"/>
              </a:ext>
            </a:extLst>
          </p:cNvPr>
          <p:cNvGrpSpPr/>
          <p:nvPr/>
        </p:nvGrpSpPr>
        <p:grpSpPr>
          <a:xfrm>
            <a:off x="50538" y="1632423"/>
            <a:ext cx="4991324" cy="4782276"/>
            <a:chOff x="50538" y="768356"/>
            <a:chExt cx="4991324" cy="4782276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E67D661-B686-3C83-9ECC-A5D0544C0B9B}"/>
                </a:ext>
              </a:extLst>
            </p:cNvPr>
            <p:cNvSpPr txBox="1"/>
            <p:nvPr/>
          </p:nvSpPr>
          <p:spPr>
            <a:xfrm>
              <a:off x="50538" y="1286357"/>
              <a:ext cx="7523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eNOS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F840002-4203-46B7-32DA-A63EE3236149}"/>
                </a:ext>
              </a:extLst>
            </p:cNvPr>
            <p:cNvSpPr txBox="1"/>
            <p:nvPr/>
          </p:nvSpPr>
          <p:spPr>
            <a:xfrm>
              <a:off x="90170" y="2754894"/>
              <a:ext cx="7577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NOS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0F8D1EB7-2B34-697D-D271-9E4F44083855}"/>
                </a:ext>
              </a:extLst>
            </p:cNvPr>
            <p:cNvGrpSpPr/>
            <p:nvPr/>
          </p:nvGrpSpPr>
          <p:grpSpPr>
            <a:xfrm>
              <a:off x="802121" y="768356"/>
              <a:ext cx="4239741" cy="4782276"/>
              <a:chOff x="111358" y="751115"/>
              <a:chExt cx="4239741" cy="4782276"/>
            </a:xfrm>
          </p:grpSpPr>
          <p:pic>
            <p:nvPicPr>
              <p:cNvPr id="12" name="Picture 11" descr="A close-up of a film&#10;&#10;Description automatically generated">
                <a:extLst>
                  <a:ext uri="{FF2B5EF4-FFF2-40B4-BE49-F238E27FC236}">
                    <a16:creationId xmlns:a16="http://schemas.microsoft.com/office/drawing/2014/main" id="{40270AF6-AEC0-217A-AFCF-57DBB9B9E27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6632" t="19355" r="11579" b="16873"/>
              <a:stretch/>
            </p:blipFill>
            <p:spPr>
              <a:xfrm>
                <a:off x="477695" y="1036186"/>
                <a:ext cx="1969335" cy="1485630"/>
              </a:xfrm>
              <a:prstGeom prst="rect">
                <a:avLst/>
              </a:prstGeom>
            </p:spPr>
          </p:pic>
          <p:pic>
            <p:nvPicPr>
              <p:cNvPr id="13" name="Picture 12" descr="A close-up of a grid&#10;&#10;Description automatically generated">
                <a:extLst>
                  <a:ext uri="{FF2B5EF4-FFF2-40B4-BE49-F238E27FC236}">
                    <a16:creationId xmlns:a16="http://schemas.microsoft.com/office/drawing/2014/main" id="{E80AB109-477E-D5FE-E0EC-04E21AB23F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5579" t="25490" r="10316" b="11275"/>
              <a:stretch/>
            </p:blipFill>
            <p:spPr>
              <a:xfrm>
                <a:off x="474808" y="4037827"/>
                <a:ext cx="2021544" cy="1481547"/>
              </a:xfrm>
              <a:prstGeom prst="rect">
                <a:avLst/>
              </a:prstGeom>
            </p:spPr>
          </p:pic>
          <p:pic>
            <p:nvPicPr>
              <p:cNvPr id="14" name="Picture 13" descr="A close-up of a dna test&#10;&#10;Description automatically generated">
                <a:extLst>
                  <a:ext uri="{FF2B5EF4-FFF2-40B4-BE49-F238E27FC236}">
                    <a16:creationId xmlns:a16="http://schemas.microsoft.com/office/drawing/2014/main" id="{9D055D4C-C2D4-E853-C2DB-1D6C53CC6E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2210" t="26341" r="19368" b="11757"/>
              <a:stretch/>
            </p:blipFill>
            <p:spPr>
              <a:xfrm>
                <a:off x="2463272" y="4038151"/>
                <a:ext cx="1884473" cy="1482213"/>
              </a:xfrm>
              <a:prstGeom prst="rect">
                <a:avLst/>
              </a:prstGeom>
            </p:spPr>
          </p:pic>
          <p:pic>
            <p:nvPicPr>
              <p:cNvPr id="15" name="Picture 14" descr="A black and white photo of a film&#10;&#10;Description automatically generated">
                <a:extLst>
                  <a:ext uri="{FF2B5EF4-FFF2-40B4-BE49-F238E27FC236}">
                    <a16:creationId xmlns:a16="http://schemas.microsoft.com/office/drawing/2014/main" id="{06C253AD-F192-FD34-DF73-B986147A94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2000" t="23078" r="18526" b="14603"/>
              <a:stretch/>
            </p:blipFill>
            <p:spPr>
              <a:xfrm>
                <a:off x="2463042" y="1040124"/>
                <a:ext cx="1886940" cy="1486879"/>
              </a:xfrm>
              <a:prstGeom prst="rect">
                <a:avLst/>
              </a:prstGeom>
            </p:spPr>
          </p:pic>
          <p:pic>
            <p:nvPicPr>
              <p:cNvPr id="16" name="Picture 15" descr="A white sheet with black lines&#10;&#10;Description automatically generated">
                <a:extLst>
                  <a:ext uri="{FF2B5EF4-FFF2-40B4-BE49-F238E27FC236}">
                    <a16:creationId xmlns:a16="http://schemas.microsoft.com/office/drawing/2014/main" id="{49FA99AA-E579-1661-0A34-D2AB7214DE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6000" t="25000" r="12210" b="14604"/>
              <a:stretch/>
            </p:blipFill>
            <p:spPr>
              <a:xfrm>
                <a:off x="476497" y="2583307"/>
                <a:ext cx="1969331" cy="1407913"/>
              </a:xfrm>
              <a:prstGeom prst="rect">
                <a:avLst/>
              </a:prstGeom>
            </p:spPr>
          </p:pic>
          <p:pic>
            <p:nvPicPr>
              <p:cNvPr id="17" name="Picture 16" descr="A close-up of a test&#10;&#10;Description automatically generated">
                <a:extLst>
                  <a:ext uri="{FF2B5EF4-FFF2-40B4-BE49-F238E27FC236}">
                    <a16:creationId xmlns:a16="http://schemas.microsoft.com/office/drawing/2014/main" id="{C4E80D3A-1F04-D22C-B924-98AFCFBF43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2211" t="25122" r="18316" b="13701"/>
              <a:stretch/>
            </p:blipFill>
            <p:spPr>
              <a:xfrm>
                <a:off x="2463821" y="2584380"/>
                <a:ext cx="1886945" cy="1405399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F31D559-2632-B052-E11A-291442F5F836}"/>
                  </a:ext>
                </a:extLst>
              </p:cNvPr>
              <p:cNvSpPr txBox="1"/>
              <p:nvPr/>
            </p:nvSpPr>
            <p:spPr>
              <a:xfrm>
                <a:off x="443989" y="856797"/>
                <a:ext cx="1977969" cy="184666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MW LC               RT-F                              RT-M          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39DD2F58-AECC-7833-8FAB-E09D0C307F1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99481" y="1017960"/>
                <a:ext cx="163448" cy="17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28470FF7-55E3-515A-FD09-08BC3F28D9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52339" y="1015121"/>
                <a:ext cx="722738" cy="403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0A3E3379-55A6-F081-1474-DA4A7F76DD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1148" y="1018663"/>
                <a:ext cx="761044" cy="35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0412AE1-2C9C-F904-389D-287849EFE484}"/>
                  </a:ext>
                </a:extLst>
              </p:cNvPr>
              <p:cNvSpPr txBox="1"/>
              <p:nvPr/>
            </p:nvSpPr>
            <p:spPr>
              <a:xfrm>
                <a:off x="111358" y="810553"/>
                <a:ext cx="3245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9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B8A1CDE-FB4E-3CF3-31C1-E379920004E3}"/>
                  </a:ext>
                </a:extLst>
              </p:cNvPr>
              <p:cNvSpPr txBox="1"/>
              <p:nvPr/>
            </p:nvSpPr>
            <p:spPr>
              <a:xfrm>
                <a:off x="2445940" y="855166"/>
                <a:ext cx="1904366" cy="184666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MW LC            TN-F                            TN-M           </a:t>
                </a:r>
                <a:endParaRPr 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059CE1FC-F27D-894A-FB7F-B6D9E44C41A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826475" y="1014227"/>
                <a:ext cx="648785" cy="377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6C4C1986-0114-9723-B958-A089FE58797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675568" y="1013547"/>
                <a:ext cx="688051" cy="34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F071C98C-5DE2-BAA2-AAC3-5BB764F112E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572803" y="1013960"/>
                <a:ext cx="200149" cy="884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>
                <a:extLst>
                  <a:ext uri="{FF2B5EF4-FFF2-40B4-BE49-F238E27FC236}">
                    <a16:creationId xmlns:a16="http://schemas.microsoft.com/office/drawing/2014/main" id="{419F7860-D06D-BDEF-B9A6-638529D546EB}"/>
                  </a:ext>
                </a:extLst>
              </p:cNvPr>
              <p:cNvCxnSpPr/>
              <p:nvPr/>
            </p:nvCxnSpPr>
            <p:spPr>
              <a:xfrm>
                <a:off x="2438400" y="751115"/>
                <a:ext cx="51087" cy="478227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503FE92B-B6F3-2514-7E9A-3718EB096D43}"/>
                  </a:ext>
                </a:extLst>
              </p:cNvPr>
              <p:cNvSpPr/>
              <p:nvPr/>
            </p:nvSpPr>
            <p:spPr>
              <a:xfrm>
                <a:off x="562069" y="1327842"/>
                <a:ext cx="1855959" cy="26405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97A98E2D-5FF1-0C32-811F-15F540FC78D3}"/>
                  </a:ext>
                </a:extLst>
              </p:cNvPr>
              <p:cNvSpPr/>
              <p:nvPr/>
            </p:nvSpPr>
            <p:spPr>
              <a:xfrm>
                <a:off x="535663" y="2761307"/>
                <a:ext cx="1908770" cy="26405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9150F67E-BCDC-9B96-8241-9D91C0093AE6}"/>
                  </a:ext>
                </a:extLst>
              </p:cNvPr>
              <p:cNvSpPr/>
              <p:nvPr/>
            </p:nvSpPr>
            <p:spPr>
              <a:xfrm>
                <a:off x="531890" y="4236267"/>
                <a:ext cx="1908770" cy="26405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2F4CDFD9-AE86-A39C-3C67-2F514B31FEEA}"/>
                  </a:ext>
                </a:extLst>
              </p:cNvPr>
              <p:cNvSpPr/>
              <p:nvPr/>
            </p:nvSpPr>
            <p:spPr>
              <a:xfrm>
                <a:off x="2509740" y="1266603"/>
                <a:ext cx="1840870" cy="26405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70A57ED5-8748-FDFB-15E5-2E9CD0F97874}"/>
                  </a:ext>
                </a:extLst>
              </p:cNvPr>
              <p:cNvSpPr/>
              <p:nvPr/>
            </p:nvSpPr>
            <p:spPr>
              <a:xfrm>
                <a:off x="2495140" y="2762776"/>
                <a:ext cx="1855959" cy="244267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2CF93308-B51A-5D46-B12C-B4B4D2AC88F5}"/>
                  </a:ext>
                </a:extLst>
              </p:cNvPr>
              <p:cNvSpPr/>
              <p:nvPr/>
            </p:nvSpPr>
            <p:spPr>
              <a:xfrm>
                <a:off x="2495140" y="4237296"/>
                <a:ext cx="1855959" cy="26405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522348B-EB8D-92E2-A6ED-BEF40AC7F290}"/>
                </a:ext>
              </a:extLst>
            </p:cNvPr>
            <p:cNvSpPr txBox="1"/>
            <p:nvPr/>
          </p:nvSpPr>
          <p:spPr>
            <a:xfrm>
              <a:off x="850023" y="1278987"/>
              <a:ext cx="4713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FF87D027-A055-6960-860D-558659BAC27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54610" y="1395336"/>
              <a:ext cx="5385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21461576-8AB2-B324-235A-692DA8D6FE4A}"/>
                </a:ext>
              </a:extLst>
            </p:cNvPr>
            <p:cNvCxnSpPr>
              <a:cxnSpLocks/>
            </p:cNvCxnSpPr>
            <p:nvPr/>
          </p:nvCxnSpPr>
          <p:spPr>
            <a:xfrm>
              <a:off x="1151273" y="1594457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2709B88-99D6-CAB1-918F-462E70E1B677}"/>
                </a:ext>
              </a:extLst>
            </p:cNvPr>
            <p:cNvSpPr txBox="1"/>
            <p:nvPr/>
          </p:nvSpPr>
          <p:spPr>
            <a:xfrm>
              <a:off x="849614" y="1471581"/>
              <a:ext cx="8684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7873988D-9135-D531-3B4E-5771399E3BDD}"/>
                </a:ext>
              </a:extLst>
            </p:cNvPr>
            <p:cNvCxnSpPr>
              <a:cxnSpLocks/>
            </p:cNvCxnSpPr>
            <p:nvPr/>
          </p:nvCxnSpPr>
          <p:spPr>
            <a:xfrm>
              <a:off x="1241988" y="1441989"/>
              <a:ext cx="146356" cy="0"/>
            </a:xfrm>
            <a:prstGeom prst="straightConnector1">
              <a:avLst/>
            </a:prstGeom>
            <a:ln w="158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53C37E2-4173-1BD4-31E0-B4DC57BF7AD6}"/>
                </a:ext>
              </a:extLst>
            </p:cNvPr>
            <p:cNvSpPr txBox="1"/>
            <p:nvPr/>
          </p:nvSpPr>
          <p:spPr>
            <a:xfrm>
              <a:off x="858744" y="2900090"/>
              <a:ext cx="7678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DD03616-E4CB-420E-C251-83205CEA4CBE}"/>
                </a:ext>
              </a:extLst>
            </p:cNvPr>
            <p:cNvSpPr txBox="1"/>
            <p:nvPr/>
          </p:nvSpPr>
          <p:spPr>
            <a:xfrm>
              <a:off x="855169" y="2712942"/>
              <a:ext cx="9557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FEEDE37E-4651-0FCD-6C61-8C2A873384EF}"/>
                </a:ext>
              </a:extLst>
            </p:cNvPr>
            <p:cNvCxnSpPr>
              <a:cxnSpLocks/>
            </p:cNvCxnSpPr>
            <p:nvPr/>
          </p:nvCxnSpPr>
          <p:spPr>
            <a:xfrm>
              <a:off x="1158357" y="2834155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6D1971F7-B093-2C5E-B54D-3C501C3CF2CC}"/>
                </a:ext>
              </a:extLst>
            </p:cNvPr>
            <p:cNvCxnSpPr>
              <a:cxnSpLocks/>
            </p:cNvCxnSpPr>
            <p:nvPr/>
          </p:nvCxnSpPr>
          <p:spPr>
            <a:xfrm>
              <a:off x="1155020" y="3024378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C687EFF2-67F9-2B64-B956-30125EAF3074}"/>
                </a:ext>
              </a:extLst>
            </p:cNvPr>
            <p:cNvCxnSpPr>
              <a:cxnSpLocks/>
            </p:cNvCxnSpPr>
            <p:nvPr/>
          </p:nvCxnSpPr>
          <p:spPr>
            <a:xfrm>
              <a:off x="1245630" y="2889753"/>
              <a:ext cx="146356" cy="0"/>
            </a:xfrm>
            <a:prstGeom prst="straightConnector1">
              <a:avLst/>
            </a:prstGeom>
            <a:ln w="158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5FD75C2-ECE9-1D73-B47D-E894AA4B6C4A}"/>
                </a:ext>
              </a:extLst>
            </p:cNvPr>
            <p:cNvSpPr txBox="1"/>
            <p:nvPr/>
          </p:nvSpPr>
          <p:spPr>
            <a:xfrm>
              <a:off x="838833" y="4191704"/>
              <a:ext cx="554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43CF574-391F-DDBC-8E07-8F517F470DAC}"/>
                </a:ext>
              </a:extLst>
            </p:cNvPr>
            <p:cNvSpPr txBox="1"/>
            <p:nvPr/>
          </p:nvSpPr>
          <p:spPr>
            <a:xfrm>
              <a:off x="840363" y="4389580"/>
              <a:ext cx="6007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80C45F0F-533B-D694-F007-88B647610465}"/>
                </a:ext>
              </a:extLst>
            </p:cNvPr>
            <p:cNvCxnSpPr>
              <a:cxnSpLocks/>
            </p:cNvCxnSpPr>
            <p:nvPr/>
          </p:nvCxnSpPr>
          <p:spPr>
            <a:xfrm>
              <a:off x="1130286" y="4307823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D0DBD370-5DEA-EE82-30CF-E4741107127F}"/>
                </a:ext>
              </a:extLst>
            </p:cNvPr>
            <p:cNvCxnSpPr>
              <a:cxnSpLocks/>
            </p:cNvCxnSpPr>
            <p:nvPr/>
          </p:nvCxnSpPr>
          <p:spPr>
            <a:xfrm>
              <a:off x="1138902" y="4512090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2BC477EB-29D8-5E0F-B7EB-EFE0DFBB3CF9}"/>
              </a:ext>
            </a:extLst>
          </p:cNvPr>
          <p:cNvGrpSpPr/>
          <p:nvPr/>
        </p:nvGrpSpPr>
        <p:grpSpPr>
          <a:xfrm>
            <a:off x="5427481" y="1716039"/>
            <a:ext cx="6909598" cy="3416138"/>
            <a:chOff x="5427481" y="1720636"/>
            <a:chExt cx="6909598" cy="3416138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13D19959-8E37-205C-4747-E2814A35ED0A}"/>
                </a:ext>
              </a:extLst>
            </p:cNvPr>
            <p:cNvSpPr txBox="1"/>
            <p:nvPr/>
          </p:nvSpPr>
          <p:spPr>
            <a:xfrm>
              <a:off x="6347048" y="1721837"/>
              <a:ext cx="30302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W LC         RT-M                         TN-M                 RT-M          TN-M</a:t>
              </a:r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B1E1B5A2-E0B7-7DC8-03B5-33D76326A784}"/>
                </a:ext>
              </a:extLst>
            </p:cNvPr>
            <p:cNvCxnSpPr>
              <a:cxnSpLocks/>
            </p:cNvCxnSpPr>
            <p:nvPr/>
          </p:nvCxnSpPr>
          <p:spPr>
            <a:xfrm>
              <a:off x="6424519" y="1893030"/>
              <a:ext cx="325493" cy="359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C93E8687-9BDE-88D1-B8F3-072CB3030C7C}"/>
                </a:ext>
              </a:extLst>
            </p:cNvPr>
            <p:cNvCxnSpPr>
              <a:cxnSpLocks/>
            </p:cNvCxnSpPr>
            <p:nvPr/>
          </p:nvCxnSpPr>
          <p:spPr>
            <a:xfrm>
              <a:off x="6831830" y="1897068"/>
              <a:ext cx="5286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B7B262BD-E23B-AA19-6EE5-79CB5AF90BF2}"/>
                </a:ext>
              </a:extLst>
            </p:cNvPr>
            <p:cNvCxnSpPr>
              <a:cxnSpLocks/>
            </p:cNvCxnSpPr>
            <p:nvPr/>
          </p:nvCxnSpPr>
          <p:spPr>
            <a:xfrm>
              <a:off x="7615366" y="1893576"/>
              <a:ext cx="58012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A83F4FB5-C013-E482-7B4D-D65565F6B2A8}"/>
                </a:ext>
              </a:extLst>
            </p:cNvPr>
            <p:cNvCxnSpPr>
              <a:cxnSpLocks/>
            </p:cNvCxnSpPr>
            <p:nvPr/>
          </p:nvCxnSpPr>
          <p:spPr>
            <a:xfrm>
              <a:off x="8282420" y="1892894"/>
              <a:ext cx="533471" cy="47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5F449322-04BB-13AD-A4FD-973B0857FA01}"/>
                </a:ext>
              </a:extLst>
            </p:cNvPr>
            <p:cNvSpPr txBox="1"/>
            <p:nvPr/>
          </p:nvSpPr>
          <p:spPr>
            <a:xfrm>
              <a:off x="9305986" y="1720636"/>
              <a:ext cx="3031093" cy="200055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MW LC        RT-F               TN-F            RT-F              TN-F           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7DC20CDC-2C39-8D7C-F1A7-C76990D844FD}"/>
                </a:ext>
              </a:extLst>
            </p:cNvPr>
            <p:cNvCxnSpPr>
              <a:cxnSpLocks/>
            </p:cNvCxnSpPr>
            <p:nvPr/>
          </p:nvCxnSpPr>
          <p:spPr>
            <a:xfrm>
              <a:off x="8897628" y="1897258"/>
              <a:ext cx="2356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E9E19749-C166-BE39-5DC6-9B4ADC898DBE}"/>
                </a:ext>
              </a:extLst>
            </p:cNvPr>
            <p:cNvCxnSpPr>
              <a:cxnSpLocks/>
            </p:cNvCxnSpPr>
            <p:nvPr/>
          </p:nvCxnSpPr>
          <p:spPr>
            <a:xfrm>
              <a:off x="9442811" y="1897236"/>
              <a:ext cx="238809" cy="12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A5DB2446-7FA4-589A-6C84-569FA19BD0F8}"/>
                </a:ext>
              </a:extLst>
            </p:cNvPr>
            <p:cNvCxnSpPr>
              <a:cxnSpLocks/>
            </p:cNvCxnSpPr>
            <p:nvPr/>
          </p:nvCxnSpPr>
          <p:spPr>
            <a:xfrm>
              <a:off x="9730904" y="1898400"/>
              <a:ext cx="52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BAC9B82A-8ACC-4676-DA33-89B98E161930}"/>
                </a:ext>
              </a:extLst>
            </p:cNvPr>
            <p:cNvCxnSpPr>
              <a:cxnSpLocks/>
            </p:cNvCxnSpPr>
            <p:nvPr/>
          </p:nvCxnSpPr>
          <p:spPr>
            <a:xfrm>
              <a:off x="10839169" y="1894806"/>
              <a:ext cx="48623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743B86C0-EC0C-63E6-764C-8E22A8AC0333}"/>
                </a:ext>
              </a:extLst>
            </p:cNvPr>
            <p:cNvCxnSpPr>
              <a:cxnSpLocks/>
            </p:cNvCxnSpPr>
            <p:nvPr/>
          </p:nvCxnSpPr>
          <p:spPr>
            <a:xfrm>
              <a:off x="11420986" y="1897594"/>
              <a:ext cx="38551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6659584F-8D5D-3B61-4CFF-FAC3E881A1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382113" y="1895149"/>
              <a:ext cx="361288" cy="88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BE620398-FA67-852D-C77B-0D37B619A8EB}"/>
                </a:ext>
              </a:extLst>
            </p:cNvPr>
            <p:cNvCxnSpPr>
              <a:cxnSpLocks/>
            </p:cNvCxnSpPr>
            <p:nvPr/>
          </p:nvCxnSpPr>
          <p:spPr>
            <a:xfrm>
              <a:off x="9258427" y="1723801"/>
              <a:ext cx="9767" cy="341297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748217CF-32C9-8EF5-A5E3-A19C9ACB03F1}"/>
                </a:ext>
              </a:extLst>
            </p:cNvPr>
            <p:cNvSpPr txBox="1"/>
            <p:nvPr/>
          </p:nvSpPr>
          <p:spPr>
            <a:xfrm>
              <a:off x="6071245" y="1765776"/>
              <a:ext cx="3553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9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5" name="Group 134">
              <a:extLst>
                <a:ext uri="{FF2B5EF4-FFF2-40B4-BE49-F238E27FC236}">
                  <a16:creationId xmlns:a16="http://schemas.microsoft.com/office/drawing/2014/main" id="{3EB32AE8-9880-2C0E-E974-BAB8FA44E617}"/>
                </a:ext>
              </a:extLst>
            </p:cNvPr>
            <p:cNvGrpSpPr/>
            <p:nvPr/>
          </p:nvGrpSpPr>
          <p:grpSpPr>
            <a:xfrm>
              <a:off x="6375443" y="4127521"/>
              <a:ext cx="2878776" cy="1005127"/>
              <a:chOff x="6821129" y="3970550"/>
              <a:chExt cx="2493850" cy="714468"/>
            </a:xfrm>
          </p:grpSpPr>
          <p:pic>
            <p:nvPicPr>
              <p:cNvPr id="134" name="Picture 133" descr="A grey rectangular object with lines&#10;&#10;Description automatically generated">
                <a:extLst>
                  <a:ext uri="{FF2B5EF4-FFF2-40B4-BE49-F238E27FC236}">
                    <a16:creationId xmlns:a16="http://schemas.microsoft.com/office/drawing/2014/main" id="{53CDA979-7E2A-2DDB-DDA7-9162430571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3315" t="37415" r="5774" b="13100"/>
              <a:stretch/>
            </p:blipFill>
            <p:spPr>
              <a:xfrm>
                <a:off x="6821129" y="3970550"/>
                <a:ext cx="2493850" cy="714468"/>
              </a:xfrm>
              <a:prstGeom prst="rect">
                <a:avLst/>
              </a:prstGeom>
            </p:spPr>
          </p:pic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027BF344-58EA-AE62-15C7-F2D809D9197D}"/>
                  </a:ext>
                </a:extLst>
              </p:cNvPr>
              <p:cNvSpPr/>
              <p:nvPr/>
            </p:nvSpPr>
            <p:spPr>
              <a:xfrm>
                <a:off x="6822332" y="4385961"/>
                <a:ext cx="2491885" cy="24082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A491BFFC-7324-074F-55B0-0FA202E7FE43}"/>
                </a:ext>
              </a:extLst>
            </p:cNvPr>
            <p:cNvGrpSpPr/>
            <p:nvPr/>
          </p:nvGrpSpPr>
          <p:grpSpPr>
            <a:xfrm>
              <a:off x="6374486" y="3016258"/>
              <a:ext cx="2868123" cy="998813"/>
              <a:chOff x="6820172" y="3216719"/>
              <a:chExt cx="2494979" cy="664948"/>
            </a:xfrm>
          </p:grpSpPr>
          <p:pic>
            <p:nvPicPr>
              <p:cNvPr id="130" name="Picture 129" descr="A black and white photo of a rectangular object&#10;&#10;Description automatically generated">
                <a:extLst>
                  <a:ext uri="{FF2B5EF4-FFF2-40B4-BE49-F238E27FC236}">
                    <a16:creationId xmlns:a16="http://schemas.microsoft.com/office/drawing/2014/main" id="{D7E05C84-6EED-71FF-318D-298F300E95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5014" t="33237" r="5180" b="17919"/>
              <a:stretch/>
            </p:blipFill>
            <p:spPr>
              <a:xfrm>
                <a:off x="6820172" y="3216719"/>
                <a:ext cx="2494979" cy="664948"/>
              </a:xfrm>
              <a:prstGeom prst="rect">
                <a:avLst/>
              </a:prstGeom>
            </p:spPr>
          </p:pic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DA26D89E-9720-F2CD-7974-388A42AE84D2}"/>
                  </a:ext>
                </a:extLst>
              </p:cNvPr>
              <p:cNvSpPr/>
              <p:nvPr/>
            </p:nvSpPr>
            <p:spPr>
              <a:xfrm>
                <a:off x="6854942" y="3610563"/>
                <a:ext cx="2418948" cy="268325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47DD5A2A-3905-9DDE-1FED-18B2A5A7B07C}"/>
                </a:ext>
              </a:extLst>
            </p:cNvPr>
            <p:cNvGrpSpPr/>
            <p:nvPr/>
          </p:nvGrpSpPr>
          <p:grpSpPr>
            <a:xfrm>
              <a:off x="6374417" y="1923240"/>
              <a:ext cx="2871575" cy="997114"/>
              <a:chOff x="6820103" y="2481133"/>
              <a:chExt cx="2494503" cy="663249"/>
            </a:xfrm>
          </p:grpSpPr>
          <p:pic>
            <p:nvPicPr>
              <p:cNvPr id="129" name="Picture 128" descr="A close-up of a piece of paper&#10;&#10;Description automatically generated">
                <a:extLst>
                  <a:ext uri="{FF2B5EF4-FFF2-40B4-BE49-F238E27FC236}">
                    <a16:creationId xmlns:a16="http://schemas.microsoft.com/office/drawing/2014/main" id="{38979681-E6DD-1ABF-9A80-1A96CEFB31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3486" t="34419" r="4435" b="13804"/>
              <a:stretch/>
            </p:blipFill>
            <p:spPr>
              <a:xfrm>
                <a:off x="6820103" y="2481133"/>
                <a:ext cx="2494503" cy="663249"/>
              </a:xfrm>
              <a:prstGeom prst="rect">
                <a:avLst/>
              </a:prstGeom>
            </p:spPr>
          </p:pic>
          <p:sp>
            <p:nvSpPr>
              <p:cNvPr id="110" name="Rectangle 109">
                <a:extLst>
                  <a:ext uri="{FF2B5EF4-FFF2-40B4-BE49-F238E27FC236}">
                    <a16:creationId xmlns:a16="http://schemas.microsoft.com/office/drawing/2014/main" id="{610EAD15-BF40-A7DC-8746-A46F96DD91DF}"/>
                  </a:ext>
                </a:extLst>
              </p:cNvPr>
              <p:cNvSpPr/>
              <p:nvPr/>
            </p:nvSpPr>
            <p:spPr>
              <a:xfrm>
                <a:off x="6821619" y="2876650"/>
                <a:ext cx="2464054" cy="26405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128" name="Picture 127" descr="A close-up of a white object&#10;&#10;Description automatically generated">
              <a:extLst>
                <a:ext uri="{FF2B5EF4-FFF2-40B4-BE49-F238E27FC236}">
                  <a16:creationId xmlns:a16="http://schemas.microsoft.com/office/drawing/2014/main" id="{A4CBB739-20C4-C170-A7C5-9A15FC43CE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3566" t="22411" r="9726" b="37564"/>
            <a:stretch/>
          </p:blipFill>
          <p:spPr>
            <a:xfrm>
              <a:off x="9275085" y="1929743"/>
              <a:ext cx="2660399" cy="1007246"/>
            </a:xfrm>
            <a:prstGeom prst="rect">
              <a:avLst/>
            </a:prstGeom>
          </p:spPr>
        </p:pic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492D37ED-A4B5-0790-CB2C-9770435A7EE6}"/>
                </a:ext>
              </a:extLst>
            </p:cNvPr>
            <p:cNvSpPr/>
            <p:nvPr/>
          </p:nvSpPr>
          <p:spPr>
            <a:xfrm>
              <a:off x="9328792" y="2482016"/>
              <a:ext cx="2557609" cy="357216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32" name="Picture 131" descr="A close-up of a rectangular object&#10;&#10;Description automatically generated">
              <a:extLst>
                <a:ext uri="{FF2B5EF4-FFF2-40B4-BE49-F238E27FC236}">
                  <a16:creationId xmlns:a16="http://schemas.microsoft.com/office/drawing/2014/main" id="{61FF1950-950B-4DDB-37E2-265F5D5148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8909" t="21063" r="9002" b="36686"/>
            <a:stretch/>
          </p:blipFill>
          <p:spPr>
            <a:xfrm>
              <a:off x="9272562" y="3016221"/>
              <a:ext cx="2660630" cy="999288"/>
            </a:xfrm>
            <a:prstGeom prst="rect">
              <a:avLst/>
            </a:prstGeom>
          </p:spPr>
        </p:pic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D4C9C2CA-B1BA-A5D8-8CA7-A2D8F499FBEE}"/>
                </a:ext>
              </a:extLst>
            </p:cNvPr>
            <p:cNvSpPr/>
            <p:nvPr/>
          </p:nvSpPr>
          <p:spPr>
            <a:xfrm>
              <a:off x="9354135" y="3618887"/>
              <a:ext cx="2553624" cy="340711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33" name="Picture 132" descr="A close-up of a grey object&#10;&#10;Description automatically generated">
              <a:extLst>
                <a:ext uri="{FF2B5EF4-FFF2-40B4-BE49-F238E27FC236}">
                  <a16:creationId xmlns:a16="http://schemas.microsoft.com/office/drawing/2014/main" id="{61C41343-17F4-1DCC-2D32-ADBD94A547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7712" t="23684" r="5454" b="34898"/>
            <a:stretch/>
          </p:blipFill>
          <p:spPr>
            <a:xfrm>
              <a:off x="9269815" y="4127826"/>
              <a:ext cx="2661495" cy="1003972"/>
            </a:xfrm>
            <a:prstGeom prst="rect">
              <a:avLst/>
            </a:prstGeom>
          </p:spPr>
        </p:pic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8ED61ED1-D1D9-E534-8938-70C225797320}"/>
                </a:ext>
              </a:extLst>
            </p:cNvPr>
            <p:cNvSpPr/>
            <p:nvPr/>
          </p:nvSpPr>
          <p:spPr>
            <a:xfrm>
              <a:off x="9330549" y="4719558"/>
              <a:ext cx="2566798" cy="329421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73C8F27-FC1E-6E08-F3BB-51C60E63084A}"/>
                </a:ext>
              </a:extLst>
            </p:cNvPr>
            <p:cNvSpPr txBox="1"/>
            <p:nvPr/>
          </p:nvSpPr>
          <p:spPr>
            <a:xfrm>
              <a:off x="5430609" y="2491735"/>
              <a:ext cx="7523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eNOS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9608C0B-97C1-139B-F162-34F00A5ECC60}"/>
                </a:ext>
              </a:extLst>
            </p:cNvPr>
            <p:cNvSpPr txBox="1"/>
            <p:nvPr/>
          </p:nvSpPr>
          <p:spPr>
            <a:xfrm>
              <a:off x="6054411" y="2533738"/>
              <a:ext cx="4713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2BD1F005-4B68-6764-5C62-842A6FF6052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58998" y="2650087"/>
              <a:ext cx="5385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AA26E5D8-A2C7-C3FA-DC49-67C2A381D76D}"/>
                </a:ext>
              </a:extLst>
            </p:cNvPr>
            <p:cNvCxnSpPr>
              <a:cxnSpLocks/>
            </p:cNvCxnSpPr>
            <p:nvPr/>
          </p:nvCxnSpPr>
          <p:spPr>
            <a:xfrm>
              <a:off x="6355661" y="2849208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48DA95A1-D298-F016-7F0F-BF0B90289AF8}"/>
                </a:ext>
              </a:extLst>
            </p:cNvPr>
            <p:cNvSpPr txBox="1"/>
            <p:nvPr/>
          </p:nvSpPr>
          <p:spPr>
            <a:xfrm>
              <a:off x="6054002" y="2726332"/>
              <a:ext cx="8684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122" name="Straight Arrow Connector 121">
              <a:extLst>
                <a:ext uri="{FF2B5EF4-FFF2-40B4-BE49-F238E27FC236}">
                  <a16:creationId xmlns:a16="http://schemas.microsoft.com/office/drawing/2014/main" id="{9449DE94-EB34-0B13-3BED-D47B619DC4F2}"/>
                </a:ext>
              </a:extLst>
            </p:cNvPr>
            <p:cNvCxnSpPr>
              <a:cxnSpLocks/>
            </p:cNvCxnSpPr>
            <p:nvPr/>
          </p:nvCxnSpPr>
          <p:spPr>
            <a:xfrm>
              <a:off x="6446376" y="2712077"/>
              <a:ext cx="146356" cy="0"/>
            </a:xfrm>
            <a:prstGeom prst="straightConnector1">
              <a:avLst/>
            </a:prstGeom>
            <a:ln w="158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DA7C2C9-F2A3-DA32-3FBE-5C8C4D627143}"/>
                </a:ext>
              </a:extLst>
            </p:cNvPr>
            <p:cNvSpPr txBox="1"/>
            <p:nvPr/>
          </p:nvSpPr>
          <p:spPr>
            <a:xfrm>
              <a:off x="5457239" y="3598986"/>
              <a:ext cx="7577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NOS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F7D4247B-5221-FDC0-2BCB-73070E15608A}"/>
                </a:ext>
              </a:extLst>
            </p:cNvPr>
            <p:cNvSpPr txBox="1"/>
            <p:nvPr/>
          </p:nvSpPr>
          <p:spPr>
            <a:xfrm>
              <a:off x="6062793" y="3797704"/>
              <a:ext cx="7678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74C4826-FF69-69FF-E056-CACC2F4A6EB4}"/>
                </a:ext>
              </a:extLst>
            </p:cNvPr>
            <p:cNvSpPr txBox="1"/>
            <p:nvPr/>
          </p:nvSpPr>
          <p:spPr>
            <a:xfrm>
              <a:off x="6059218" y="3610556"/>
              <a:ext cx="9557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12C10F90-B19C-E4C3-4BE5-97A5FDCD1CEB}"/>
                </a:ext>
              </a:extLst>
            </p:cNvPr>
            <p:cNvCxnSpPr>
              <a:cxnSpLocks/>
            </p:cNvCxnSpPr>
            <p:nvPr/>
          </p:nvCxnSpPr>
          <p:spPr>
            <a:xfrm>
              <a:off x="6362406" y="3731769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7A615A3C-EA63-7D45-9249-A2AC44839AAA}"/>
                </a:ext>
              </a:extLst>
            </p:cNvPr>
            <p:cNvCxnSpPr>
              <a:cxnSpLocks/>
            </p:cNvCxnSpPr>
            <p:nvPr/>
          </p:nvCxnSpPr>
          <p:spPr>
            <a:xfrm>
              <a:off x="6359069" y="3921992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Straight Arrow Connector 123">
              <a:extLst>
                <a:ext uri="{FF2B5EF4-FFF2-40B4-BE49-F238E27FC236}">
                  <a16:creationId xmlns:a16="http://schemas.microsoft.com/office/drawing/2014/main" id="{5455738C-079B-3468-0205-6D5BB98D395F}"/>
                </a:ext>
              </a:extLst>
            </p:cNvPr>
            <p:cNvCxnSpPr>
              <a:cxnSpLocks/>
            </p:cNvCxnSpPr>
            <p:nvPr/>
          </p:nvCxnSpPr>
          <p:spPr>
            <a:xfrm>
              <a:off x="6449679" y="3787367"/>
              <a:ext cx="146356" cy="0"/>
            </a:xfrm>
            <a:prstGeom prst="straightConnector1">
              <a:avLst/>
            </a:prstGeom>
            <a:ln w="158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1F50B92-D830-7006-B1F3-4150A501270D}"/>
                </a:ext>
              </a:extLst>
            </p:cNvPr>
            <p:cNvSpPr txBox="1"/>
            <p:nvPr/>
          </p:nvSpPr>
          <p:spPr>
            <a:xfrm>
              <a:off x="5427481" y="4646983"/>
              <a:ext cx="87627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tal protein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7A102372-C9C2-DAAD-3EB9-E1C23AA38ACE}"/>
                </a:ext>
              </a:extLst>
            </p:cNvPr>
            <p:cNvSpPr txBox="1"/>
            <p:nvPr/>
          </p:nvSpPr>
          <p:spPr>
            <a:xfrm>
              <a:off x="6043896" y="4644754"/>
              <a:ext cx="554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967E6935-C57E-55E4-4329-65511EC47F60}"/>
                </a:ext>
              </a:extLst>
            </p:cNvPr>
            <p:cNvSpPr txBox="1"/>
            <p:nvPr/>
          </p:nvSpPr>
          <p:spPr>
            <a:xfrm>
              <a:off x="6045426" y="4842631"/>
              <a:ext cx="6007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005E152E-632C-02AE-2464-287C1767E750}"/>
                </a:ext>
              </a:extLst>
            </p:cNvPr>
            <p:cNvCxnSpPr>
              <a:cxnSpLocks/>
            </p:cNvCxnSpPr>
            <p:nvPr/>
          </p:nvCxnSpPr>
          <p:spPr>
            <a:xfrm>
              <a:off x="6335349" y="4760873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66AAB81D-A978-B9EE-ED4E-72F28982F26D}"/>
                </a:ext>
              </a:extLst>
            </p:cNvPr>
            <p:cNvCxnSpPr>
              <a:cxnSpLocks/>
            </p:cNvCxnSpPr>
            <p:nvPr/>
          </p:nvCxnSpPr>
          <p:spPr>
            <a:xfrm>
              <a:off x="6343965" y="4965140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99BBE234-314E-0FD4-F6BF-BECE62CC0985}"/>
              </a:ext>
            </a:extLst>
          </p:cNvPr>
          <p:cNvSpPr txBox="1"/>
          <p:nvPr/>
        </p:nvSpPr>
        <p:spPr>
          <a:xfrm>
            <a:off x="1040352" y="925601"/>
            <a:ext cx="52360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4A: PVAT whole blo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317997-DAD1-8599-8878-CABDC7E5D70B}"/>
              </a:ext>
            </a:extLst>
          </p:cNvPr>
          <p:cNvSpPr txBox="1"/>
          <p:nvPr/>
        </p:nvSpPr>
        <p:spPr>
          <a:xfrm>
            <a:off x="6285345" y="916827"/>
            <a:ext cx="52360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4B: aorta whole blo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B0A0AB7-2E05-0214-0839-433CAE75757C}"/>
              </a:ext>
            </a:extLst>
          </p:cNvPr>
          <p:cNvSpPr txBox="1"/>
          <p:nvPr/>
        </p:nvSpPr>
        <p:spPr>
          <a:xfrm>
            <a:off x="-4824" y="-44721"/>
            <a:ext cx="11425809" cy="115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00" b="1" dirty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en-US" sz="23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blots depicting representative images used for Figures 4A and 4B. </a:t>
            </a:r>
            <a:r>
              <a:rPr lang="en-US" sz="2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orta blots for </a:t>
            </a:r>
            <a:r>
              <a:rPr lang="en-US" sz="2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NOS</a:t>
            </a:r>
            <a:r>
              <a:rPr lang="en-US" sz="2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US" sz="2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OS</a:t>
            </a:r>
            <a:r>
              <a:rPr lang="en-US" sz="2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re cut at 75 </a:t>
            </a:r>
            <a:r>
              <a:rPr lang="en-US" sz="23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23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</a:p>
          <a:p>
            <a:endParaRPr lang="en-US" sz="2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4117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02F34440-935C-31DE-1424-A138A89CE9AE}"/>
              </a:ext>
            </a:extLst>
          </p:cNvPr>
          <p:cNvGrpSpPr/>
          <p:nvPr/>
        </p:nvGrpSpPr>
        <p:grpSpPr>
          <a:xfrm>
            <a:off x="2437923" y="3623257"/>
            <a:ext cx="5802642" cy="3076939"/>
            <a:chOff x="8802" y="478036"/>
            <a:chExt cx="5802642" cy="3076939"/>
          </a:xfrm>
        </p:grpSpPr>
        <p:pic>
          <p:nvPicPr>
            <p:cNvPr id="3" name="Picture 2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F8595B9E-5BFB-0480-2B27-F7C570112F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9118" t="29067" r="16597" b="13503"/>
            <a:stretch/>
          </p:blipFill>
          <p:spPr>
            <a:xfrm>
              <a:off x="3252834" y="654235"/>
              <a:ext cx="2110626" cy="1450699"/>
            </a:xfrm>
            <a:prstGeom prst="rect">
              <a:avLst/>
            </a:prstGeom>
          </p:spPr>
        </p:pic>
        <p:pic>
          <p:nvPicPr>
            <p:cNvPr id="5" name="Picture 4" descr="A close-up of a grid&#10;&#10;Description automatically generated">
              <a:extLst>
                <a:ext uri="{FF2B5EF4-FFF2-40B4-BE49-F238E27FC236}">
                  <a16:creationId xmlns:a16="http://schemas.microsoft.com/office/drawing/2014/main" id="{F4DCA7B9-3A2E-0D24-2287-CFCE34C254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062" t="19277" r="13474" b="23919"/>
            <a:stretch/>
          </p:blipFill>
          <p:spPr>
            <a:xfrm>
              <a:off x="1049185" y="2167287"/>
              <a:ext cx="2142995" cy="1351800"/>
            </a:xfrm>
            <a:prstGeom prst="rect">
              <a:avLst/>
            </a:prstGeom>
          </p:spPr>
        </p:pic>
        <p:pic>
          <p:nvPicPr>
            <p:cNvPr id="6" name="Picture 5" descr="A close-up of a test&#10;&#10;Description automatically generated">
              <a:extLst>
                <a:ext uri="{FF2B5EF4-FFF2-40B4-BE49-F238E27FC236}">
                  <a16:creationId xmlns:a16="http://schemas.microsoft.com/office/drawing/2014/main" id="{455A8920-7B16-70FC-07EC-3FD97169EF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631" t="16748" r="16031" b="22411"/>
            <a:stretch/>
          </p:blipFill>
          <p:spPr>
            <a:xfrm>
              <a:off x="1011960" y="653856"/>
              <a:ext cx="2176385" cy="1447952"/>
            </a:xfrm>
            <a:prstGeom prst="rect">
              <a:avLst/>
            </a:prstGeom>
          </p:spPr>
        </p:pic>
        <p:pic>
          <p:nvPicPr>
            <p:cNvPr id="7" name="Picture 6" descr="A close-up of a white sheet&#10;&#10;Description automatically generated">
              <a:extLst>
                <a:ext uri="{FF2B5EF4-FFF2-40B4-BE49-F238E27FC236}">
                  <a16:creationId xmlns:a16="http://schemas.microsoft.com/office/drawing/2014/main" id="{DFE631E8-A650-E27E-0820-9E65879789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479" t="26203" r="17397" b="19333"/>
            <a:stretch/>
          </p:blipFill>
          <p:spPr>
            <a:xfrm>
              <a:off x="3242624" y="2172839"/>
              <a:ext cx="2145752" cy="1350114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714BE5F-4151-9B41-F8B4-E355352723DC}"/>
                </a:ext>
              </a:extLst>
            </p:cNvPr>
            <p:cNvSpPr txBox="1"/>
            <p:nvPr/>
          </p:nvSpPr>
          <p:spPr>
            <a:xfrm>
              <a:off x="1025774" y="493807"/>
              <a:ext cx="2231971" cy="184666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 MW               RT-F                                   RT-M                 LC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5B19E86C-C930-DF63-C244-85D71B476F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11861" y="478036"/>
              <a:ext cx="1617" cy="303517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794C18E3-44F9-71AE-0D69-E92F1466AD62}"/>
                </a:ext>
              </a:extLst>
            </p:cNvPr>
            <p:cNvCxnSpPr>
              <a:cxnSpLocks/>
            </p:cNvCxnSpPr>
            <p:nvPr/>
          </p:nvCxnSpPr>
          <p:spPr>
            <a:xfrm>
              <a:off x="3049445" y="639547"/>
              <a:ext cx="9895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DD3DB39-B2AA-E3ED-1F9E-5CD0A58BE2CD}"/>
                </a:ext>
              </a:extLst>
            </p:cNvPr>
            <p:cNvCxnSpPr>
              <a:cxnSpLocks/>
            </p:cNvCxnSpPr>
            <p:nvPr/>
          </p:nvCxnSpPr>
          <p:spPr>
            <a:xfrm>
              <a:off x="2254576" y="635859"/>
              <a:ext cx="730877" cy="510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FB3D5366-A069-BE18-CD0D-5A01745E386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98955" y="636874"/>
              <a:ext cx="782772" cy="319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BCDE065-1271-2538-2E83-EFF57D0BBE6A}"/>
                </a:ext>
              </a:extLst>
            </p:cNvPr>
            <p:cNvSpPr txBox="1"/>
            <p:nvPr/>
          </p:nvSpPr>
          <p:spPr>
            <a:xfrm>
              <a:off x="3186847" y="493549"/>
              <a:ext cx="2152033" cy="184666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MW  LC              TN-F                                 TN-M     </a:t>
              </a:r>
              <a:endParaRPr lang="en-US" sz="6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D3AAA554-BF72-0A03-F115-341A08DB7F0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69861" y="635397"/>
              <a:ext cx="826091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F69BBBF9-0B0C-02BB-3E6A-29BDB17EDD9B}"/>
                </a:ext>
              </a:extLst>
            </p:cNvPr>
            <p:cNvCxnSpPr>
              <a:cxnSpLocks/>
            </p:cNvCxnSpPr>
            <p:nvPr/>
          </p:nvCxnSpPr>
          <p:spPr>
            <a:xfrm>
              <a:off x="4448345" y="639629"/>
              <a:ext cx="827085" cy="95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DC3278A-BBC9-4A25-7112-D91D0CDBED59}"/>
                </a:ext>
              </a:extLst>
            </p:cNvPr>
            <p:cNvSpPr txBox="1"/>
            <p:nvPr/>
          </p:nvSpPr>
          <p:spPr>
            <a:xfrm>
              <a:off x="29711" y="1144717"/>
              <a:ext cx="7673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xPho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C0DD1F8-9AB2-47B2-A66E-2A1E5349938F}"/>
                </a:ext>
              </a:extLst>
            </p:cNvPr>
            <p:cNvSpPr txBox="1"/>
            <p:nvPr/>
          </p:nvSpPr>
          <p:spPr>
            <a:xfrm>
              <a:off x="8802" y="2616259"/>
              <a:ext cx="6868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47FF76EC-13C7-15C5-E6E5-70318BAA6C1A}"/>
                </a:ext>
              </a:extLst>
            </p:cNvPr>
            <p:cNvCxnSpPr>
              <a:cxnSpLocks/>
            </p:cNvCxnSpPr>
            <p:nvPr/>
          </p:nvCxnSpPr>
          <p:spPr>
            <a:xfrm>
              <a:off x="3335028" y="639201"/>
              <a:ext cx="20193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98CB777-6811-86D2-3B73-8BFEAE149454}"/>
                </a:ext>
              </a:extLst>
            </p:cNvPr>
            <p:cNvSpPr txBox="1"/>
            <p:nvPr/>
          </p:nvSpPr>
          <p:spPr>
            <a:xfrm>
              <a:off x="762096" y="2587273"/>
              <a:ext cx="3546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78670DA-5D9E-C7F3-FF1D-CB1CF4107513}"/>
                </a:ext>
              </a:extLst>
            </p:cNvPr>
            <p:cNvSpPr txBox="1"/>
            <p:nvPr/>
          </p:nvSpPr>
          <p:spPr>
            <a:xfrm>
              <a:off x="759023" y="2775309"/>
              <a:ext cx="3163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A434F7D-B34F-C9BF-338E-244E99D2DCA1}"/>
                </a:ext>
              </a:extLst>
            </p:cNvPr>
            <p:cNvSpPr txBox="1"/>
            <p:nvPr/>
          </p:nvSpPr>
          <p:spPr>
            <a:xfrm>
              <a:off x="761469" y="2942369"/>
              <a:ext cx="3106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9852A5E-5F07-4B64-C8BA-99E0156D4ECA}"/>
                </a:ext>
              </a:extLst>
            </p:cNvPr>
            <p:cNvSpPr txBox="1"/>
            <p:nvPr/>
          </p:nvSpPr>
          <p:spPr>
            <a:xfrm>
              <a:off x="766284" y="3137137"/>
              <a:ext cx="3504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9D978C5-4ADE-810E-7B10-160DA531837F}"/>
                </a:ext>
              </a:extLst>
            </p:cNvPr>
            <p:cNvSpPr txBox="1"/>
            <p:nvPr/>
          </p:nvSpPr>
          <p:spPr>
            <a:xfrm>
              <a:off x="764279" y="3370309"/>
              <a:ext cx="32774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B32BDE30-75B5-43FA-C751-F49D4EAC4566}"/>
                </a:ext>
              </a:extLst>
            </p:cNvPr>
            <p:cNvSpPr txBox="1"/>
            <p:nvPr/>
          </p:nvSpPr>
          <p:spPr>
            <a:xfrm>
              <a:off x="716847" y="964734"/>
              <a:ext cx="45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48576678-17E4-469C-B75C-C08C7E0ADD23}"/>
                </a:ext>
              </a:extLst>
            </p:cNvPr>
            <p:cNvCxnSpPr>
              <a:cxnSpLocks/>
            </p:cNvCxnSpPr>
            <p:nvPr/>
          </p:nvCxnSpPr>
          <p:spPr>
            <a:xfrm>
              <a:off x="1158925" y="635609"/>
              <a:ext cx="100846" cy="359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074DAA89-2692-4315-D924-B34E03666856}"/>
                </a:ext>
              </a:extLst>
            </p:cNvPr>
            <p:cNvSpPr/>
            <p:nvPr/>
          </p:nvSpPr>
          <p:spPr>
            <a:xfrm>
              <a:off x="1048963" y="1131525"/>
              <a:ext cx="2138130" cy="947243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20EE3554-EAE6-2DA3-ECB5-F19C506AAA31}"/>
                </a:ext>
              </a:extLst>
            </p:cNvPr>
            <p:cNvSpPr/>
            <p:nvPr/>
          </p:nvSpPr>
          <p:spPr>
            <a:xfrm>
              <a:off x="3259752" y="1133147"/>
              <a:ext cx="2080167" cy="947242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94300AD0-6A21-4F53-85D9-E3029D291AEF}"/>
                </a:ext>
              </a:extLst>
            </p:cNvPr>
            <p:cNvSpPr/>
            <p:nvPr/>
          </p:nvSpPr>
          <p:spPr>
            <a:xfrm>
              <a:off x="1068569" y="2618193"/>
              <a:ext cx="2086036" cy="884288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8851696-2857-9637-5BD9-1F8105154C2B}"/>
                </a:ext>
              </a:extLst>
            </p:cNvPr>
            <p:cNvSpPr/>
            <p:nvPr/>
          </p:nvSpPr>
          <p:spPr>
            <a:xfrm>
              <a:off x="3272115" y="2617502"/>
              <a:ext cx="2089359" cy="879898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EE6089F-DB08-6153-7464-9C460D22D962}"/>
                </a:ext>
              </a:extLst>
            </p:cNvPr>
            <p:cNvSpPr txBox="1"/>
            <p:nvPr/>
          </p:nvSpPr>
          <p:spPr>
            <a:xfrm>
              <a:off x="746104" y="1119650"/>
              <a:ext cx="302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E7D0B8E-BE13-CF01-DB33-5A1B295FBD9E}"/>
                </a:ext>
              </a:extLst>
            </p:cNvPr>
            <p:cNvSpPr txBox="1"/>
            <p:nvPr/>
          </p:nvSpPr>
          <p:spPr>
            <a:xfrm>
              <a:off x="751564" y="1324790"/>
              <a:ext cx="3022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3BA79F0-E42B-A02C-B8E1-E7466D756EA8}"/>
                </a:ext>
              </a:extLst>
            </p:cNvPr>
            <p:cNvSpPr txBox="1"/>
            <p:nvPr/>
          </p:nvSpPr>
          <p:spPr>
            <a:xfrm>
              <a:off x="755150" y="1493712"/>
              <a:ext cx="3016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D7CC307-080F-6C41-335F-A12B6D50CBD4}"/>
                </a:ext>
              </a:extLst>
            </p:cNvPr>
            <p:cNvSpPr txBox="1"/>
            <p:nvPr/>
          </p:nvSpPr>
          <p:spPr>
            <a:xfrm>
              <a:off x="757206" y="1702714"/>
              <a:ext cx="2767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2E43724-DB5F-EB5A-2DF5-3CF7B77BB733}"/>
                </a:ext>
              </a:extLst>
            </p:cNvPr>
            <p:cNvSpPr txBox="1"/>
            <p:nvPr/>
          </p:nvSpPr>
          <p:spPr>
            <a:xfrm>
              <a:off x="758165" y="1920538"/>
              <a:ext cx="30381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0FEACE58-FE66-FDFF-77A7-BA1D83E80E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79587" y="1210709"/>
              <a:ext cx="799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068E31B8-8F1B-B87B-8EE1-B4A9B41F330C}"/>
                </a:ext>
              </a:extLst>
            </p:cNvPr>
            <p:cNvCxnSpPr>
              <a:cxnSpLocks/>
            </p:cNvCxnSpPr>
            <p:nvPr/>
          </p:nvCxnSpPr>
          <p:spPr>
            <a:xfrm>
              <a:off x="978637" y="1416916"/>
              <a:ext cx="9058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042BF4AE-B643-9826-D492-BC5A1C2C95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82787" y="1580076"/>
              <a:ext cx="8698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0B5B1FDB-3124-6871-2470-0912E1FEEEBC}"/>
                </a:ext>
              </a:extLst>
            </p:cNvPr>
            <p:cNvCxnSpPr>
              <a:cxnSpLocks/>
            </p:cNvCxnSpPr>
            <p:nvPr/>
          </p:nvCxnSpPr>
          <p:spPr>
            <a:xfrm>
              <a:off x="978589" y="1786028"/>
              <a:ext cx="9058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69E179C-2D6E-7A58-ADF6-BBC016B7ABF0}"/>
                </a:ext>
              </a:extLst>
            </p:cNvPr>
            <p:cNvCxnSpPr>
              <a:cxnSpLocks/>
            </p:cNvCxnSpPr>
            <p:nvPr/>
          </p:nvCxnSpPr>
          <p:spPr>
            <a:xfrm>
              <a:off x="979773" y="1897310"/>
              <a:ext cx="9058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09AE2824-8C06-BCB5-A89E-73A109929634}"/>
                </a:ext>
              </a:extLst>
            </p:cNvPr>
            <p:cNvCxnSpPr>
              <a:cxnSpLocks/>
            </p:cNvCxnSpPr>
            <p:nvPr/>
          </p:nvCxnSpPr>
          <p:spPr>
            <a:xfrm>
              <a:off x="978861" y="2008398"/>
              <a:ext cx="8698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EBF7C6B0-8750-5C8F-F9F6-F129624A7CB0}"/>
                </a:ext>
              </a:extLst>
            </p:cNvPr>
            <p:cNvCxnSpPr>
              <a:cxnSpLocks/>
            </p:cNvCxnSpPr>
            <p:nvPr/>
          </p:nvCxnSpPr>
          <p:spPr>
            <a:xfrm>
              <a:off x="1012674" y="2680740"/>
              <a:ext cx="7620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CEB40A34-4287-EC4E-E475-C27C71C5601D}"/>
                </a:ext>
              </a:extLst>
            </p:cNvPr>
            <p:cNvCxnSpPr>
              <a:cxnSpLocks/>
            </p:cNvCxnSpPr>
            <p:nvPr/>
          </p:nvCxnSpPr>
          <p:spPr>
            <a:xfrm>
              <a:off x="1010302" y="3456723"/>
              <a:ext cx="7620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65DAEC2D-2DB7-DF4B-E0A5-DB62085B71A1}"/>
                </a:ext>
              </a:extLst>
            </p:cNvPr>
            <p:cNvCxnSpPr>
              <a:cxnSpLocks/>
            </p:cNvCxnSpPr>
            <p:nvPr/>
          </p:nvCxnSpPr>
          <p:spPr>
            <a:xfrm>
              <a:off x="1009698" y="2867659"/>
              <a:ext cx="7620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7F2DF478-66A0-6427-6229-203E198DEE0B}"/>
                </a:ext>
              </a:extLst>
            </p:cNvPr>
            <p:cNvCxnSpPr>
              <a:cxnSpLocks/>
            </p:cNvCxnSpPr>
            <p:nvPr/>
          </p:nvCxnSpPr>
          <p:spPr>
            <a:xfrm>
              <a:off x="1010880" y="3034832"/>
              <a:ext cx="7620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5F1EAA80-C4FE-BDF6-C0BE-308E867C9005}"/>
                </a:ext>
              </a:extLst>
            </p:cNvPr>
            <p:cNvCxnSpPr>
              <a:cxnSpLocks/>
            </p:cNvCxnSpPr>
            <p:nvPr/>
          </p:nvCxnSpPr>
          <p:spPr>
            <a:xfrm>
              <a:off x="1010302" y="3232735"/>
              <a:ext cx="7620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3E4EB48B-B4D2-B7A5-1AF2-B8447C48BBBE}"/>
                </a:ext>
              </a:extLst>
            </p:cNvPr>
            <p:cNvCxnSpPr>
              <a:cxnSpLocks/>
            </p:cNvCxnSpPr>
            <p:nvPr/>
          </p:nvCxnSpPr>
          <p:spPr>
            <a:xfrm>
              <a:off x="1006205" y="3331057"/>
              <a:ext cx="7620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81B93AA-54EB-191D-45BD-35FF614ECEA9}"/>
                </a:ext>
              </a:extLst>
            </p:cNvPr>
            <p:cNvSpPr txBox="1"/>
            <p:nvPr/>
          </p:nvSpPr>
          <p:spPr>
            <a:xfrm>
              <a:off x="5412277" y="1361275"/>
              <a:ext cx="3644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II 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1F35F05-3067-B39B-DC99-EFFAD892F2A0}"/>
                </a:ext>
              </a:extLst>
            </p:cNvPr>
            <p:cNvSpPr txBox="1"/>
            <p:nvPr/>
          </p:nvSpPr>
          <p:spPr>
            <a:xfrm>
              <a:off x="5411519" y="1297652"/>
              <a:ext cx="36002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V 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09880D0-C8B3-628B-D364-D6111E3C455B}"/>
                </a:ext>
              </a:extLst>
            </p:cNvPr>
            <p:cNvSpPr txBox="1"/>
            <p:nvPr/>
          </p:nvSpPr>
          <p:spPr>
            <a:xfrm>
              <a:off x="5413681" y="1434250"/>
              <a:ext cx="3977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V 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31C0D4A-DA4A-657D-CB0F-FAA589CFAD64}"/>
                </a:ext>
              </a:extLst>
            </p:cNvPr>
            <p:cNvSpPr txBox="1"/>
            <p:nvPr/>
          </p:nvSpPr>
          <p:spPr>
            <a:xfrm>
              <a:off x="5411221" y="1659798"/>
              <a:ext cx="35457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I  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EB50EB6-2164-D398-DA72-C45106588DDD}"/>
                </a:ext>
              </a:extLst>
            </p:cNvPr>
            <p:cNvSpPr txBox="1"/>
            <p:nvPr/>
          </p:nvSpPr>
          <p:spPr>
            <a:xfrm>
              <a:off x="5413226" y="1848136"/>
              <a:ext cx="2931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  </a:t>
              </a:r>
            </a:p>
          </p:txBody>
        </p: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C3522660-ADE3-3FA2-0C0E-D5591D9FEC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96483" y="1391325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BAB05CB9-2E44-4868-F918-D4355F39267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96813" y="1453283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FA686AF4-362A-4519-5241-329C739F72E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97886" y="1495371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3AC46FE2-48FC-F0DA-9A61-8A77DEDA399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96504" y="1749321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6BDDFB51-366B-7911-AAE1-F2D6604402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97583" y="1936013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CC3E67DC-A071-783A-CA70-8ADE257E6B06}"/>
              </a:ext>
            </a:extLst>
          </p:cNvPr>
          <p:cNvGrpSpPr/>
          <p:nvPr/>
        </p:nvGrpSpPr>
        <p:grpSpPr>
          <a:xfrm>
            <a:off x="2245932" y="864977"/>
            <a:ext cx="4072618" cy="2237382"/>
            <a:chOff x="6751166" y="308202"/>
            <a:chExt cx="4072618" cy="2237382"/>
          </a:xfrm>
        </p:grpSpPr>
        <p:pic>
          <p:nvPicPr>
            <p:cNvPr id="4" name="Picture 3" descr="A close-up of a test&#10;&#10;Description automatically generated">
              <a:extLst>
                <a:ext uri="{FF2B5EF4-FFF2-40B4-BE49-F238E27FC236}">
                  <a16:creationId xmlns:a16="http://schemas.microsoft.com/office/drawing/2014/main" id="{5BE188B5-A933-1472-9C31-7DEB5ADDBD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9684" t="39691" r="26737" b="6701"/>
            <a:stretch/>
          </p:blipFill>
          <p:spPr>
            <a:xfrm>
              <a:off x="7956983" y="480405"/>
              <a:ext cx="2863909" cy="990187"/>
            </a:xfrm>
            <a:prstGeom prst="rect">
              <a:avLst/>
            </a:prstGeom>
          </p:spPr>
        </p:pic>
        <p:pic>
          <p:nvPicPr>
            <p:cNvPr id="8" name="Picture 7" descr="A black and white photo of a rectangular object&#10;&#10;Description automatically generated">
              <a:extLst>
                <a:ext uri="{FF2B5EF4-FFF2-40B4-BE49-F238E27FC236}">
                  <a16:creationId xmlns:a16="http://schemas.microsoft.com/office/drawing/2014/main" id="{3C482955-D9D6-836D-81BC-40870F46C2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9895" t="37561" r="28210" b="12195"/>
            <a:stretch/>
          </p:blipFill>
          <p:spPr>
            <a:xfrm>
              <a:off x="7954418" y="1559610"/>
              <a:ext cx="2857463" cy="985974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670EDC1-14BE-DAC8-C8EF-DE930712C013}"/>
                </a:ext>
              </a:extLst>
            </p:cNvPr>
            <p:cNvSpPr txBox="1"/>
            <p:nvPr/>
          </p:nvSpPr>
          <p:spPr>
            <a:xfrm>
              <a:off x="6751166" y="1947398"/>
              <a:ext cx="8419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tal Protein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E8F49B73-6CD4-2A99-3827-3E9F98C4BB44}"/>
                </a:ext>
              </a:extLst>
            </p:cNvPr>
            <p:cNvSpPr txBox="1"/>
            <p:nvPr/>
          </p:nvSpPr>
          <p:spPr>
            <a:xfrm>
              <a:off x="6752967" y="869624"/>
              <a:ext cx="1045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GC-1α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1676396-4A35-4ACC-A2F9-5737EB15E619}"/>
                </a:ext>
              </a:extLst>
            </p:cNvPr>
            <p:cNvSpPr txBox="1"/>
            <p:nvPr/>
          </p:nvSpPr>
          <p:spPr>
            <a:xfrm>
              <a:off x="8054051" y="320978"/>
              <a:ext cx="2769733" cy="184666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MW  LC           RT-F             TN-F               RT-M                       TN-M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7499FF73-2457-C843-A942-6E429ABD1443}"/>
                </a:ext>
              </a:extLst>
            </p:cNvPr>
            <p:cNvCxnSpPr>
              <a:cxnSpLocks/>
            </p:cNvCxnSpPr>
            <p:nvPr/>
          </p:nvCxnSpPr>
          <p:spPr>
            <a:xfrm>
              <a:off x="10125562" y="460662"/>
              <a:ext cx="51767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C60D14B3-985C-02FB-3DC2-02B90918AF33}"/>
                </a:ext>
              </a:extLst>
            </p:cNvPr>
            <p:cNvCxnSpPr>
              <a:cxnSpLocks/>
            </p:cNvCxnSpPr>
            <p:nvPr/>
          </p:nvCxnSpPr>
          <p:spPr>
            <a:xfrm>
              <a:off x="9386139" y="457978"/>
              <a:ext cx="625608" cy="462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9EBAA047-4722-73C6-72D3-DE9EA7E1FCF2}"/>
                </a:ext>
              </a:extLst>
            </p:cNvPr>
            <p:cNvCxnSpPr>
              <a:cxnSpLocks/>
            </p:cNvCxnSpPr>
            <p:nvPr/>
          </p:nvCxnSpPr>
          <p:spPr>
            <a:xfrm>
              <a:off x="8494883" y="457610"/>
              <a:ext cx="45682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E11BC19E-1914-366B-BFB3-3E8EC213BD17}"/>
                </a:ext>
              </a:extLst>
            </p:cNvPr>
            <p:cNvCxnSpPr>
              <a:cxnSpLocks/>
            </p:cNvCxnSpPr>
            <p:nvPr/>
          </p:nvCxnSpPr>
          <p:spPr>
            <a:xfrm>
              <a:off x="9044794" y="459513"/>
              <a:ext cx="253534" cy="4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F234ECC-3047-F5C3-F6DA-53F018C8DEA0}"/>
                </a:ext>
              </a:extLst>
            </p:cNvPr>
            <p:cNvSpPr txBox="1"/>
            <p:nvPr/>
          </p:nvSpPr>
          <p:spPr>
            <a:xfrm>
              <a:off x="7591557" y="308202"/>
              <a:ext cx="3267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C590F308-EC76-4C12-32C2-2253124E35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142580" y="454494"/>
              <a:ext cx="283374" cy="551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11054769-5F92-4BD8-ABF2-463DCDA21417}"/>
                </a:ext>
              </a:extLst>
            </p:cNvPr>
            <p:cNvSpPr/>
            <p:nvPr/>
          </p:nvSpPr>
          <p:spPr>
            <a:xfrm>
              <a:off x="7996515" y="868214"/>
              <a:ext cx="2778472" cy="376315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2A616F67-1A40-0B1D-E508-7784F8762911}"/>
                </a:ext>
              </a:extLst>
            </p:cNvPr>
            <p:cNvSpPr/>
            <p:nvPr/>
          </p:nvSpPr>
          <p:spPr>
            <a:xfrm>
              <a:off x="7996514" y="1948265"/>
              <a:ext cx="2778472" cy="376315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1D8F9D7-5D7A-63AD-9675-9BDF6EBCBD2D}"/>
                </a:ext>
              </a:extLst>
            </p:cNvPr>
            <p:cNvSpPr txBox="1"/>
            <p:nvPr/>
          </p:nvSpPr>
          <p:spPr>
            <a:xfrm>
              <a:off x="7615041" y="841501"/>
              <a:ext cx="3770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89CFD34E-3E27-EF9B-515B-42592634B731}"/>
                </a:ext>
              </a:extLst>
            </p:cNvPr>
            <p:cNvCxnSpPr>
              <a:cxnSpLocks/>
            </p:cNvCxnSpPr>
            <p:nvPr/>
          </p:nvCxnSpPr>
          <p:spPr>
            <a:xfrm>
              <a:off x="7925550" y="1180098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66E37710-5D3C-F514-6E6C-2FEA92A3862D}"/>
                </a:ext>
              </a:extLst>
            </p:cNvPr>
            <p:cNvCxnSpPr>
              <a:cxnSpLocks/>
            </p:cNvCxnSpPr>
            <p:nvPr/>
          </p:nvCxnSpPr>
          <p:spPr>
            <a:xfrm>
              <a:off x="7927488" y="953225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66280729-4F4B-D98C-DE4A-A1E172B6649A}"/>
                </a:ext>
              </a:extLst>
            </p:cNvPr>
            <p:cNvSpPr txBox="1"/>
            <p:nvPr/>
          </p:nvSpPr>
          <p:spPr>
            <a:xfrm>
              <a:off x="7624125" y="1059892"/>
              <a:ext cx="3770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F52A1F8F-881C-7348-2797-8CEC2E2796AE}"/>
                </a:ext>
              </a:extLst>
            </p:cNvPr>
            <p:cNvSpPr txBox="1"/>
            <p:nvPr/>
          </p:nvSpPr>
          <p:spPr>
            <a:xfrm>
              <a:off x="7589057" y="1902765"/>
              <a:ext cx="3770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AE6FF056-00DB-113D-815A-4E61226AD723}"/>
                </a:ext>
              </a:extLst>
            </p:cNvPr>
            <p:cNvCxnSpPr>
              <a:cxnSpLocks/>
            </p:cNvCxnSpPr>
            <p:nvPr/>
          </p:nvCxnSpPr>
          <p:spPr>
            <a:xfrm>
              <a:off x="7891897" y="2026966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248AC01B-BF89-F089-C5D9-CE1B23C65A87}"/>
                </a:ext>
              </a:extLst>
            </p:cNvPr>
            <p:cNvCxnSpPr>
              <a:cxnSpLocks/>
            </p:cNvCxnSpPr>
            <p:nvPr/>
          </p:nvCxnSpPr>
          <p:spPr>
            <a:xfrm>
              <a:off x="7904386" y="2263349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86BED192-0111-751B-31A0-01A2DAE20040}"/>
                </a:ext>
              </a:extLst>
            </p:cNvPr>
            <p:cNvSpPr txBox="1"/>
            <p:nvPr/>
          </p:nvSpPr>
          <p:spPr>
            <a:xfrm>
              <a:off x="7594680" y="2135991"/>
              <a:ext cx="4138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E19730C-354F-34AA-4851-FC0899BB4715}"/>
              </a:ext>
            </a:extLst>
          </p:cNvPr>
          <p:cNvSpPr txBox="1"/>
          <p:nvPr/>
        </p:nvSpPr>
        <p:spPr>
          <a:xfrm>
            <a:off x="-4824" y="5613"/>
            <a:ext cx="10994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: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blots depicting representative images used for Figures 5A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ots for PGC-1</a:t>
            </a:r>
            <a:r>
              <a:rPr lang="el-GR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re cut at 75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55434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 73">
            <a:extLst>
              <a:ext uri="{FF2B5EF4-FFF2-40B4-BE49-F238E27FC236}">
                <a16:creationId xmlns:a16="http://schemas.microsoft.com/office/drawing/2014/main" id="{B0170851-1349-7E1A-7DCC-848C4B406A09}"/>
              </a:ext>
            </a:extLst>
          </p:cNvPr>
          <p:cNvGrpSpPr/>
          <p:nvPr/>
        </p:nvGrpSpPr>
        <p:grpSpPr>
          <a:xfrm>
            <a:off x="3405572" y="2777368"/>
            <a:ext cx="8725763" cy="4105270"/>
            <a:chOff x="289554" y="1181209"/>
            <a:chExt cx="8725763" cy="4105270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4378B3C-A3B4-7695-39B3-244FBC78D8FE}"/>
                </a:ext>
              </a:extLst>
            </p:cNvPr>
            <p:cNvSpPr txBox="1"/>
            <p:nvPr/>
          </p:nvSpPr>
          <p:spPr>
            <a:xfrm>
              <a:off x="8610539" y="2264729"/>
              <a:ext cx="3739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V 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57D9030-0171-E0A6-299C-42D58D69FF45}"/>
                </a:ext>
              </a:extLst>
            </p:cNvPr>
            <p:cNvSpPr txBox="1"/>
            <p:nvPr/>
          </p:nvSpPr>
          <p:spPr>
            <a:xfrm>
              <a:off x="8612703" y="2364897"/>
              <a:ext cx="3739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II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5609881-B4F8-AE1D-775E-E3CB5DA6E2BB}"/>
                </a:ext>
              </a:extLst>
            </p:cNvPr>
            <p:cNvSpPr txBox="1"/>
            <p:nvPr/>
          </p:nvSpPr>
          <p:spPr>
            <a:xfrm>
              <a:off x="8612701" y="2449058"/>
              <a:ext cx="40182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V 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CCC7A76-0339-CFEE-26A4-356B8AC00F03}"/>
                </a:ext>
              </a:extLst>
            </p:cNvPr>
            <p:cNvSpPr txBox="1"/>
            <p:nvPr/>
          </p:nvSpPr>
          <p:spPr>
            <a:xfrm>
              <a:off x="8623081" y="2734281"/>
              <a:ext cx="3861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I  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F2BA09E-7E59-2D09-42E6-E561A8A68232}"/>
                </a:ext>
              </a:extLst>
            </p:cNvPr>
            <p:cNvSpPr txBox="1"/>
            <p:nvPr/>
          </p:nvSpPr>
          <p:spPr>
            <a:xfrm>
              <a:off x="8641325" y="2952756"/>
              <a:ext cx="3739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  </a:t>
              </a: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D914C005-63B4-3397-0BDD-5768ABD168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09413" y="3046276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A8047A1F-5403-A861-5AFF-9563CBAC8E6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92611" y="2384612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5F1633AC-3A38-8040-8A19-3FD884E968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93683" y="2452298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8A35A6C0-6518-BEF3-D272-BF402C8186A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93359" y="2521642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CEF30262-555C-351C-5315-56CB049D246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94437" y="2825437"/>
              <a:ext cx="184028" cy="299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6761F6DF-9BBF-982A-9620-B8AC3B18800E}"/>
                </a:ext>
              </a:extLst>
            </p:cNvPr>
            <p:cNvGrpSpPr/>
            <p:nvPr/>
          </p:nvGrpSpPr>
          <p:grpSpPr>
            <a:xfrm>
              <a:off x="289554" y="1181209"/>
              <a:ext cx="8564538" cy="4105270"/>
              <a:chOff x="2239086" y="1705702"/>
              <a:chExt cx="8564538" cy="4105270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75BFA49-E0F5-4BA9-00B4-A5EF1E97AFF5}"/>
                  </a:ext>
                </a:extLst>
              </p:cNvPr>
              <p:cNvSpPr txBox="1"/>
              <p:nvPr/>
            </p:nvSpPr>
            <p:spPr>
              <a:xfrm>
                <a:off x="3077226" y="5595528"/>
                <a:ext cx="37392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grpSp>
            <p:nvGrpSpPr>
              <p:cNvPr id="71" name="Group 70">
                <a:extLst>
                  <a:ext uri="{FF2B5EF4-FFF2-40B4-BE49-F238E27FC236}">
                    <a16:creationId xmlns:a16="http://schemas.microsoft.com/office/drawing/2014/main" id="{B617BCFD-2A76-36B4-7C3E-B264B3AC0BFF}"/>
                  </a:ext>
                </a:extLst>
              </p:cNvPr>
              <p:cNvGrpSpPr/>
              <p:nvPr/>
            </p:nvGrpSpPr>
            <p:grpSpPr>
              <a:xfrm>
                <a:off x="3284200" y="1705702"/>
                <a:ext cx="7519424" cy="4042260"/>
                <a:chOff x="2853811" y="1719813"/>
                <a:chExt cx="7519424" cy="4042260"/>
              </a:xfrm>
            </p:grpSpPr>
            <p:pic>
              <p:nvPicPr>
                <p:cNvPr id="7" name="Picture 6" descr="A close-up of a piece of paper&#10;&#10;Description automatically generated">
                  <a:extLst>
                    <a:ext uri="{FF2B5EF4-FFF2-40B4-BE49-F238E27FC236}">
                      <a16:creationId xmlns:a16="http://schemas.microsoft.com/office/drawing/2014/main" id="{EC1B4DF5-60C5-04F3-8645-D64C765004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rcRect l="8051" t="25758" r="8574" b="15994"/>
                <a:stretch/>
              </p:blipFill>
              <p:spPr>
                <a:xfrm>
                  <a:off x="6477688" y="3857536"/>
                  <a:ext cx="3511288" cy="1883554"/>
                </a:xfrm>
                <a:prstGeom prst="rect">
                  <a:avLst/>
                </a:prstGeom>
              </p:spPr>
            </p:pic>
            <p:pic>
              <p:nvPicPr>
                <p:cNvPr id="8" name="Picture 7" descr="A close-up of a white sheet&#10;&#10;Description automatically generated">
                  <a:extLst>
                    <a:ext uri="{FF2B5EF4-FFF2-40B4-BE49-F238E27FC236}">
                      <a16:creationId xmlns:a16="http://schemas.microsoft.com/office/drawing/2014/main" id="{BA240140-D16A-0F4F-FF63-9F4778C8FC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7579" t="22515" r="10316" b="17251"/>
                <a:stretch/>
              </p:blipFill>
              <p:spPr>
                <a:xfrm>
                  <a:off x="6471318" y="1935300"/>
                  <a:ext cx="3508204" cy="1885867"/>
                </a:xfrm>
                <a:prstGeom prst="rect">
                  <a:avLst/>
                </a:prstGeom>
              </p:spPr>
            </p:pic>
            <p:pic>
              <p:nvPicPr>
                <p:cNvPr id="9" name="Picture 8" descr="A close-up of a grey and white photo&#10;&#10;Description automatically generated">
                  <a:extLst>
                    <a:ext uri="{FF2B5EF4-FFF2-40B4-BE49-F238E27FC236}">
                      <a16:creationId xmlns:a16="http://schemas.microsoft.com/office/drawing/2014/main" id="{AE2124CA-33E2-C8D5-47A4-1036E45EA3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4210" t="30086" r="5895" b="12607"/>
                <a:stretch/>
              </p:blipFill>
              <p:spPr>
                <a:xfrm>
                  <a:off x="2955320" y="3855245"/>
                  <a:ext cx="3474409" cy="1879732"/>
                </a:xfrm>
                <a:prstGeom prst="rect">
                  <a:avLst/>
                </a:prstGeom>
              </p:spPr>
            </p:pic>
            <p:pic>
              <p:nvPicPr>
                <p:cNvPr id="10" name="Picture 9" descr="A close-up of a test&#10;&#10;Description automatically generated">
                  <a:extLst>
                    <a:ext uri="{FF2B5EF4-FFF2-40B4-BE49-F238E27FC236}">
                      <a16:creationId xmlns:a16="http://schemas.microsoft.com/office/drawing/2014/main" id="{F120A413-3099-A50A-9498-3418BBD39D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5462" t="28824" r="6723" b="13235"/>
                <a:stretch/>
              </p:blipFill>
              <p:spPr>
                <a:xfrm>
                  <a:off x="2949179" y="1948270"/>
                  <a:ext cx="3477729" cy="1829769"/>
                </a:xfrm>
                <a:prstGeom prst="rect">
                  <a:avLst/>
                </a:prstGeom>
              </p:spPr>
            </p:pic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68509DE5-E070-77A1-7E7E-A31664D8437A}"/>
                    </a:ext>
                  </a:extLst>
                </p:cNvPr>
                <p:cNvSpPr txBox="1"/>
                <p:nvPr/>
              </p:nvSpPr>
              <p:spPr>
                <a:xfrm>
                  <a:off x="2853811" y="1727434"/>
                  <a:ext cx="4165600" cy="215444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r>
                    <a:rPr lang="en-US" sz="800" dirty="0">
                      <a:latin typeface="Arial"/>
                      <a:cs typeface="Arial"/>
                    </a:rPr>
                    <a:t> MW LC            RT-M                         TN-M                   RT-M             TN-M</a:t>
                  </a:r>
                </a:p>
              </p:txBody>
            </p: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567EAD03-77ED-6520-B293-F7A984E1E9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6434360" y="1726272"/>
                  <a:ext cx="15856" cy="403580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2EBAFA26-A7BC-F80B-EE8F-A6638908BF0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624546" y="1894432"/>
                  <a:ext cx="289634" cy="428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2BB7BBCA-5DE3-E017-1B57-AFCA295CA8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94517" y="1895378"/>
                  <a:ext cx="723443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79EF9EC7-42D5-E425-23C4-8468F8EE8A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97544" y="1897265"/>
                  <a:ext cx="746213" cy="428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>
                  <a:extLst>
                    <a:ext uri="{FF2B5EF4-FFF2-40B4-BE49-F238E27FC236}">
                      <a16:creationId xmlns:a16="http://schemas.microsoft.com/office/drawing/2014/main" id="{EAC041F7-2B65-48B5-7AC5-6E7F85F11A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382648" y="1896486"/>
                  <a:ext cx="744295" cy="428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B49ECC4A-BE3D-2CDA-6656-53C0D44640AC}"/>
                    </a:ext>
                  </a:extLst>
                </p:cNvPr>
                <p:cNvSpPr txBox="1"/>
                <p:nvPr/>
              </p:nvSpPr>
              <p:spPr>
                <a:xfrm>
                  <a:off x="6505409" y="1719813"/>
                  <a:ext cx="3867826" cy="215444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r>
                    <a:rPr lang="en-US" sz="800" dirty="0">
                      <a:latin typeface="Arial"/>
                      <a:cs typeface="Arial"/>
                    </a:rPr>
                    <a:t>MW  LC           RT-F                  TN-F                 RT-F                 TN-F           </a:t>
                  </a:r>
                  <a:endParaRPr lang="en-US" sz="800" u="sng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D763B7B0-9428-4691-D163-2BCF554F20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19708" y="1896844"/>
                  <a:ext cx="79976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36">
                  <a:extLst>
                    <a:ext uri="{FF2B5EF4-FFF2-40B4-BE49-F238E27FC236}">
                      <a16:creationId xmlns:a16="http://schemas.microsoft.com/office/drawing/2014/main" id="{9E9A1BC3-ECF4-1CD9-9A97-E38FA4EF95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86398" y="1896276"/>
                  <a:ext cx="500613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id="{0482CC28-D9EA-9DAE-71C8-92F2D6673F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21552" y="1895847"/>
                  <a:ext cx="68721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>
                  <a:extLst>
                    <a:ext uri="{FF2B5EF4-FFF2-40B4-BE49-F238E27FC236}">
                      <a16:creationId xmlns:a16="http://schemas.microsoft.com/office/drawing/2014/main" id="{D760222A-FE31-F4A0-59BA-5186975DAB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319331" y="1896275"/>
                  <a:ext cx="471465" cy="33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>
                  <a:extLst>
                    <a:ext uri="{FF2B5EF4-FFF2-40B4-BE49-F238E27FC236}">
                      <a16:creationId xmlns:a16="http://schemas.microsoft.com/office/drawing/2014/main" id="{7E7D7229-FE91-1EC1-7951-D04FC535FC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986339" y="1895863"/>
                  <a:ext cx="30701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>
                  <a:extLst>
                    <a:ext uri="{FF2B5EF4-FFF2-40B4-BE49-F238E27FC236}">
                      <a16:creationId xmlns:a16="http://schemas.microsoft.com/office/drawing/2014/main" id="{1CDC9DAB-F127-C0E6-0FDC-98130F77B49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985328" y="1898527"/>
                  <a:ext cx="325697" cy="428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7" name="Rectangle 66">
                  <a:extLst>
                    <a:ext uri="{FF2B5EF4-FFF2-40B4-BE49-F238E27FC236}">
                      <a16:creationId xmlns:a16="http://schemas.microsoft.com/office/drawing/2014/main" id="{E3FB9D34-795A-4A5D-0D34-522686BBC746}"/>
                    </a:ext>
                  </a:extLst>
                </p:cNvPr>
                <p:cNvSpPr/>
                <p:nvPr/>
              </p:nvSpPr>
              <p:spPr>
                <a:xfrm>
                  <a:off x="2953492" y="2636817"/>
                  <a:ext cx="3434441" cy="1140524"/>
                </a:xfrm>
                <a:prstGeom prst="rect">
                  <a:avLst/>
                </a:prstGeom>
                <a:noFill/>
                <a:ln w="28575">
                  <a:solidFill>
                    <a:srgbClr val="FFC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8" name="Rectangle 67">
                  <a:extLst>
                    <a:ext uri="{FF2B5EF4-FFF2-40B4-BE49-F238E27FC236}">
                      <a16:creationId xmlns:a16="http://schemas.microsoft.com/office/drawing/2014/main" id="{98D96550-AA9B-07BF-2645-C4D3745238D6}"/>
                    </a:ext>
                  </a:extLst>
                </p:cNvPr>
                <p:cNvSpPr/>
                <p:nvPr/>
              </p:nvSpPr>
              <p:spPr>
                <a:xfrm>
                  <a:off x="2953492" y="4534394"/>
                  <a:ext cx="3465119" cy="1212272"/>
                </a:xfrm>
                <a:prstGeom prst="rect">
                  <a:avLst/>
                </a:prstGeom>
                <a:noFill/>
                <a:ln w="28575">
                  <a:solidFill>
                    <a:srgbClr val="FFC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9" name="Rectangle 68">
                  <a:extLst>
                    <a:ext uri="{FF2B5EF4-FFF2-40B4-BE49-F238E27FC236}">
                      <a16:creationId xmlns:a16="http://schemas.microsoft.com/office/drawing/2014/main" id="{8A10C46E-4CF1-5A82-C0FF-85E84F16143C}"/>
                    </a:ext>
                  </a:extLst>
                </p:cNvPr>
                <p:cNvSpPr/>
                <p:nvPr/>
              </p:nvSpPr>
              <p:spPr>
                <a:xfrm>
                  <a:off x="6527965" y="4495304"/>
                  <a:ext cx="3450769" cy="1231569"/>
                </a:xfrm>
                <a:prstGeom prst="rect">
                  <a:avLst/>
                </a:prstGeom>
                <a:noFill/>
                <a:ln w="28575">
                  <a:solidFill>
                    <a:srgbClr val="FFC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0" name="Rectangle 69">
                  <a:extLst>
                    <a:ext uri="{FF2B5EF4-FFF2-40B4-BE49-F238E27FC236}">
                      <a16:creationId xmlns:a16="http://schemas.microsoft.com/office/drawing/2014/main" id="{7F9410D7-ACDE-C6F8-4535-3592A221B425}"/>
                    </a:ext>
                  </a:extLst>
                </p:cNvPr>
                <p:cNvSpPr/>
                <p:nvPr/>
              </p:nvSpPr>
              <p:spPr>
                <a:xfrm>
                  <a:off x="6506430" y="2610152"/>
                  <a:ext cx="3466897" cy="1176059"/>
                </a:xfrm>
                <a:prstGeom prst="rect">
                  <a:avLst/>
                </a:prstGeom>
                <a:noFill/>
                <a:ln w="28575">
                  <a:solidFill>
                    <a:srgbClr val="FFC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DDC7CF95-4FC3-D43B-3038-4A1C07FBE7EB}"/>
                  </a:ext>
                </a:extLst>
              </p:cNvPr>
              <p:cNvSpPr txBox="1"/>
              <p:nvPr/>
            </p:nvSpPr>
            <p:spPr>
              <a:xfrm>
                <a:off x="3079810" y="4532843"/>
                <a:ext cx="307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3150979E-855D-F66C-67E1-EED86EDD1DC9}"/>
                  </a:ext>
                </a:extLst>
              </p:cNvPr>
              <p:cNvSpPr txBox="1"/>
              <p:nvPr/>
            </p:nvSpPr>
            <p:spPr>
              <a:xfrm>
                <a:off x="3076235" y="4791531"/>
                <a:ext cx="4144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E5E47B4B-D5E2-8A3B-0A1A-8A6658557DBA}"/>
                  </a:ext>
                </a:extLst>
              </p:cNvPr>
              <p:cNvSpPr txBox="1"/>
              <p:nvPr/>
            </p:nvSpPr>
            <p:spPr>
              <a:xfrm>
                <a:off x="3080599" y="5009415"/>
                <a:ext cx="5357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4B76565-902B-3662-8AC2-5AD4B020A581}"/>
                  </a:ext>
                </a:extLst>
              </p:cNvPr>
              <p:cNvSpPr txBox="1"/>
              <p:nvPr/>
            </p:nvSpPr>
            <p:spPr>
              <a:xfrm>
                <a:off x="3078640" y="5265545"/>
                <a:ext cx="44282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1D55F9B5-70D2-E156-2BBF-3223F778CA7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31269" y="4641252"/>
                <a:ext cx="6198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AB660763-8117-27D5-AA86-0F56596D78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18226" y="4900126"/>
                <a:ext cx="7620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1CA1F187-2A4F-D391-7568-EBEAB11BB8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23042" y="5109827"/>
                <a:ext cx="7620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D58D18BA-B0E4-5F51-9587-E97D590E42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22439" y="5377065"/>
                <a:ext cx="7620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C2833C3A-6F22-F980-936F-DD901FD289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30809" y="5514054"/>
                <a:ext cx="7620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EE62FE6C-DA30-B96F-BC03-D2EA89641A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23043" y="5702760"/>
                <a:ext cx="7620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EDAC0DD9-7053-3696-83FB-9F013CC69438}"/>
                  </a:ext>
                </a:extLst>
              </p:cNvPr>
              <p:cNvGrpSpPr/>
              <p:nvPr/>
            </p:nvGrpSpPr>
            <p:grpSpPr>
              <a:xfrm>
                <a:off x="2242655" y="1727021"/>
                <a:ext cx="1248362" cy="2117568"/>
                <a:chOff x="1798155" y="1748188"/>
                <a:chExt cx="1248362" cy="2117568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8ADED120-A3C1-A491-902B-2E83E3A59379}"/>
                    </a:ext>
                  </a:extLst>
                </p:cNvPr>
                <p:cNvSpPr txBox="1"/>
                <p:nvPr/>
              </p:nvSpPr>
              <p:spPr>
                <a:xfrm>
                  <a:off x="2593508" y="2634625"/>
                  <a:ext cx="36956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EFD37E39-0641-CFD9-CB44-20BC8F8B2611}"/>
                    </a:ext>
                  </a:extLst>
                </p:cNvPr>
                <p:cNvSpPr txBox="1"/>
                <p:nvPr/>
              </p:nvSpPr>
              <p:spPr>
                <a:xfrm>
                  <a:off x="2579274" y="2890086"/>
                  <a:ext cx="34681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28C6A3B5-3328-4EFD-8445-30DD7BF682BD}"/>
                    </a:ext>
                  </a:extLst>
                </p:cNvPr>
                <p:cNvSpPr txBox="1"/>
                <p:nvPr/>
              </p:nvSpPr>
              <p:spPr>
                <a:xfrm>
                  <a:off x="2575670" y="3078851"/>
                  <a:ext cx="41746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80646FFE-EB21-F438-07CB-D9BE249B245D}"/>
                    </a:ext>
                  </a:extLst>
                </p:cNvPr>
                <p:cNvSpPr txBox="1"/>
                <p:nvPr/>
              </p:nvSpPr>
              <p:spPr>
                <a:xfrm>
                  <a:off x="2580458" y="3352403"/>
                  <a:ext cx="4258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DA67B860-D9F8-A4B8-0D6D-3CD83F7E3006}"/>
                    </a:ext>
                  </a:extLst>
                </p:cNvPr>
                <p:cNvSpPr txBox="1"/>
                <p:nvPr/>
              </p:nvSpPr>
              <p:spPr>
                <a:xfrm>
                  <a:off x="2567904" y="3650312"/>
                  <a:ext cx="46423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CD9C6426-3E04-8B63-DF61-28B1562BBA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885739" y="2741785"/>
                  <a:ext cx="6198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340639F4-8D40-4988-FCA4-35DBB6795D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84788" y="2998313"/>
                  <a:ext cx="7620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F0F82D9B-A2D1-12A3-9017-CD8C32D0276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74565" y="3186633"/>
                  <a:ext cx="7620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06B791C6-E790-82CA-8E2E-0C6A82AF5D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73958" y="3446501"/>
                  <a:ext cx="7620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D80C8EF5-6B81-B602-3890-E1389919748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75143" y="3582943"/>
                  <a:ext cx="7620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2614CCE8-6DEA-D55C-6F7E-9C4FF0D2B2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70636" y="3758728"/>
                  <a:ext cx="7620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A591B667-7B8B-F2C8-6AAB-7BE5A0EAB3DF}"/>
                    </a:ext>
                  </a:extLst>
                </p:cNvPr>
                <p:cNvSpPr txBox="1"/>
                <p:nvPr/>
              </p:nvSpPr>
              <p:spPr>
                <a:xfrm>
                  <a:off x="2594246" y="1748188"/>
                  <a:ext cx="4522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u="sng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endParaRPr lang="en-US" sz="800" u="sng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74B3BAFB-9A17-4486-F618-277CCB67D712}"/>
                    </a:ext>
                  </a:extLst>
                </p:cNvPr>
                <p:cNvSpPr txBox="1"/>
                <p:nvPr/>
              </p:nvSpPr>
              <p:spPr>
                <a:xfrm>
                  <a:off x="1798155" y="2634407"/>
                  <a:ext cx="76739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OxPhos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3B3F871E-365E-5105-E372-632AF92A45B4}"/>
                  </a:ext>
                </a:extLst>
              </p:cNvPr>
              <p:cNvSpPr txBox="1"/>
              <p:nvPr/>
            </p:nvSpPr>
            <p:spPr>
              <a:xfrm>
                <a:off x="2239086" y="4532538"/>
                <a:ext cx="70702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otein</a:t>
                </a:r>
              </a:p>
            </p:txBody>
          </p:sp>
        </p:grp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26554813-E30D-62B1-84E1-5C029E28EE78}"/>
              </a:ext>
            </a:extLst>
          </p:cNvPr>
          <p:cNvGrpSpPr/>
          <p:nvPr/>
        </p:nvGrpSpPr>
        <p:grpSpPr>
          <a:xfrm>
            <a:off x="3131785" y="155452"/>
            <a:ext cx="8868374" cy="2274197"/>
            <a:chOff x="2204001" y="4403482"/>
            <a:chExt cx="8868374" cy="2274197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D9B5ED97-603B-F2AD-2F10-B21F4294A7EE}"/>
                </a:ext>
              </a:extLst>
            </p:cNvPr>
            <p:cNvSpPr txBox="1"/>
            <p:nvPr/>
          </p:nvSpPr>
          <p:spPr>
            <a:xfrm>
              <a:off x="2204001" y="6216014"/>
              <a:ext cx="8419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tal Protein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A784FBD-1659-056C-1A92-8C527327AF06}"/>
                </a:ext>
              </a:extLst>
            </p:cNvPr>
            <p:cNvSpPr txBox="1"/>
            <p:nvPr/>
          </p:nvSpPr>
          <p:spPr>
            <a:xfrm>
              <a:off x="2238647" y="5228087"/>
              <a:ext cx="1045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GC-1α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F3A36195-B5D6-480E-1761-7206BC58E894}"/>
                </a:ext>
              </a:extLst>
            </p:cNvPr>
            <p:cNvSpPr txBox="1"/>
            <p:nvPr/>
          </p:nvSpPr>
          <p:spPr>
            <a:xfrm>
              <a:off x="3610076" y="4406225"/>
              <a:ext cx="3725411" cy="215444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800" dirty="0">
                  <a:latin typeface="Arial"/>
                  <a:cs typeface="Arial"/>
                </a:rPr>
                <a:t>MW  LC           RT-M                              TN-M                    RT-M              TN-M</a:t>
              </a: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F049A919-D43B-77C7-8E03-850D70725CE6}"/>
                </a:ext>
              </a:extLst>
            </p:cNvPr>
            <p:cNvCxnSpPr>
              <a:cxnSpLocks/>
            </p:cNvCxnSpPr>
            <p:nvPr/>
          </p:nvCxnSpPr>
          <p:spPr>
            <a:xfrm>
              <a:off x="7524171" y="4575027"/>
              <a:ext cx="32978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6CFA2CCF-BE24-37E4-553D-1AEA79085E38}"/>
                </a:ext>
              </a:extLst>
            </p:cNvPr>
            <p:cNvCxnSpPr>
              <a:cxnSpLocks/>
            </p:cNvCxnSpPr>
            <p:nvPr/>
          </p:nvCxnSpPr>
          <p:spPr>
            <a:xfrm>
              <a:off x="5258846" y="4574418"/>
              <a:ext cx="76624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C0AEC3BE-FF0A-9C61-CEDC-A1D0F9ACB0A9}"/>
                </a:ext>
              </a:extLst>
            </p:cNvPr>
            <p:cNvCxnSpPr>
              <a:cxnSpLocks/>
            </p:cNvCxnSpPr>
            <p:nvPr/>
          </p:nvCxnSpPr>
          <p:spPr>
            <a:xfrm>
              <a:off x="7935795" y="4580622"/>
              <a:ext cx="77487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9F2FC1ED-7BEB-1F9F-0689-64729E9E2B52}"/>
                </a:ext>
              </a:extLst>
            </p:cNvPr>
            <p:cNvCxnSpPr>
              <a:cxnSpLocks/>
            </p:cNvCxnSpPr>
            <p:nvPr/>
          </p:nvCxnSpPr>
          <p:spPr>
            <a:xfrm>
              <a:off x="6098983" y="4574418"/>
              <a:ext cx="736390" cy="11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BF2E89DF-FB09-29B5-9463-6187ADCE1D81}"/>
                </a:ext>
              </a:extLst>
            </p:cNvPr>
            <p:cNvSpPr txBox="1"/>
            <p:nvPr/>
          </p:nvSpPr>
          <p:spPr>
            <a:xfrm>
              <a:off x="3222512" y="5197421"/>
              <a:ext cx="3770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3726FB40-411C-4877-F328-5BBF7915FC33}"/>
                </a:ext>
              </a:extLst>
            </p:cNvPr>
            <p:cNvCxnSpPr>
              <a:cxnSpLocks/>
            </p:cNvCxnSpPr>
            <p:nvPr/>
          </p:nvCxnSpPr>
          <p:spPr>
            <a:xfrm>
              <a:off x="3533021" y="5536018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0609EF12-6FF4-5232-B0B2-EEDAAB06C614}"/>
                </a:ext>
              </a:extLst>
            </p:cNvPr>
            <p:cNvSpPr txBox="1"/>
            <p:nvPr/>
          </p:nvSpPr>
          <p:spPr>
            <a:xfrm>
              <a:off x="3281882" y="4403482"/>
              <a:ext cx="3267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9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1B798B2-7D9B-68F7-B371-B4ADC1B39FB4}"/>
                </a:ext>
              </a:extLst>
            </p:cNvPr>
            <p:cNvSpPr txBox="1"/>
            <p:nvPr/>
          </p:nvSpPr>
          <p:spPr>
            <a:xfrm>
              <a:off x="7418536" y="4407788"/>
              <a:ext cx="3653839" cy="215444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800" dirty="0">
                  <a:latin typeface="Arial"/>
                  <a:cs typeface="Arial"/>
                </a:rPr>
                <a:t>MW  LC           RT-F                   TN-F                 RT-F                TN-F           </a:t>
              </a:r>
              <a:endParaRPr lang="en-US" sz="8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AE69F720-224C-0CCC-CE66-C4C1E096F723}"/>
                </a:ext>
              </a:extLst>
            </p:cNvPr>
            <p:cNvCxnSpPr>
              <a:cxnSpLocks/>
            </p:cNvCxnSpPr>
            <p:nvPr/>
          </p:nvCxnSpPr>
          <p:spPr>
            <a:xfrm>
              <a:off x="9444988" y="4583370"/>
              <a:ext cx="65051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7510814B-4C02-9625-EA38-9A27AA8B5BE0}"/>
                </a:ext>
              </a:extLst>
            </p:cNvPr>
            <p:cNvCxnSpPr>
              <a:cxnSpLocks/>
            </p:cNvCxnSpPr>
            <p:nvPr/>
          </p:nvCxnSpPr>
          <p:spPr>
            <a:xfrm>
              <a:off x="8798757" y="4581877"/>
              <a:ext cx="56890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9975BF3F-A8E4-3B45-815C-3E1DB8A4DFDD}"/>
                </a:ext>
              </a:extLst>
            </p:cNvPr>
            <p:cNvCxnSpPr>
              <a:cxnSpLocks/>
            </p:cNvCxnSpPr>
            <p:nvPr/>
          </p:nvCxnSpPr>
          <p:spPr>
            <a:xfrm>
              <a:off x="10208003" y="4577078"/>
              <a:ext cx="529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BF446AF8-C855-824A-9F31-6DAEBF7B0B9A}"/>
                </a:ext>
              </a:extLst>
            </p:cNvPr>
            <p:cNvCxnSpPr>
              <a:cxnSpLocks/>
            </p:cNvCxnSpPr>
            <p:nvPr/>
          </p:nvCxnSpPr>
          <p:spPr>
            <a:xfrm>
              <a:off x="4196953" y="4578766"/>
              <a:ext cx="676698" cy="16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6C62D383-DA7C-FEDF-A110-39D5B580C9FC}"/>
                </a:ext>
              </a:extLst>
            </p:cNvPr>
            <p:cNvSpPr txBox="1"/>
            <p:nvPr/>
          </p:nvSpPr>
          <p:spPr>
            <a:xfrm>
              <a:off x="3227254" y="6206981"/>
              <a:ext cx="3770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78A42FED-5090-4020-C9E4-6E55B0451C23}"/>
                </a:ext>
              </a:extLst>
            </p:cNvPr>
            <p:cNvCxnSpPr>
              <a:cxnSpLocks/>
            </p:cNvCxnSpPr>
            <p:nvPr/>
          </p:nvCxnSpPr>
          <p:spPr>
            <a:xfrm>
              <a:off x="3534959" y="5309145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AB0761C3-A1E4-D8A4-067A-C7D2C7352D2D}"/>
                </a:ext>
              </a:extLst>
            </p:cNvPr>
            <p:cNvCxnSpPr>
              <a:cxnSpLocks/>
            </p:cNvCxnSpPr>
            <p:nvPr/>
          </p:nvCxnSpPr>
          <p:spPr>
            <a:xfrm>
              <a:off x="3530094" y="6331182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48EE7DF9-EEDD-6F50-8571-630F378D9263}"/>
                </a:ext>
              </a:extLst>
            </p:cNvPr>
            <p:cNvCxnSpPr>
              <a:cxnSpLocks/>
            </p:cNvCxnSpPr>
            <p:nvPr/>
          </p:nvCxnSpPr>
          <p:spPr>
            <a:xfrm>
              <a:off x="3542583" y="6567565"/>
              <a:ext cx="6621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E03B0BD5-8DB1-DA58-3A8D-55138E461843}"/>
                </a:ext>
              </a:extLst>
            </p:cNvPr>
            <p:cNvSpPr txBox="1"/>
            <p:nvPr/>
          </p:nvSpPr>
          <p:spPr>
            <a:xfrm>
              <a:off x="3232878" y="6446776"/>
              <a:ext cx="4138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A60DB853-D995-AC18-D956-548FF16D0EA6}"/>
                </a:ext>
              </a:extLst>
            </p:cNvPr>
            <p:cNvSpPr txBox="1"/>
            <p:nvPr/>
          </p:nvSpPr>
          <p:spPr>
            <a:xfrm>
              <a:off x="3231596" y="5415812"/>
              <a:ext cx="3770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54270669-DC16-F75A-4198-C587A9EEC412}"/>
                </a:ext>
              </a:extLst>
            </p:cNvPr>
            <p:cNvCxnSpPr>
              <a:cxnSpLocks/>
            </p:cNvCxnSpPr>
            <p:nvPr/>
          </p:nvCxnSpPr>
          <p:spPr>
            <a:xfrm>
              <a:off x="3684062" y="4576318"/>
              <a:ext cx="422751" cy="11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931E92D8-7580-8069-661F-119A22CA4019}"/>
                </a:ext>
              </a:extLst>
            </p:cNvPr>
            <p:cNvCxnSpPr>
              <a:cxnSpLocks/>
            </p:cNvCxnSpPr>
            <p:nvPr/>
          </p:nvCxnSpPr>
          <p:spPr>
            <a:xfrm>
              <a:off x="6908965" y="4574727"/>
              <a:ext cx="343923" cy="11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16AB2FE2-A647-0F16-E86E-88F02A7AE432}"/>
                </a:ext>
              </a:extLst>
            </p:cNvPr>
            <p:cNvGrpSpPr/>
            <p:nvPr/>
          </p:nvGrpSpPr>
          <p:grpSpPr>
            <a:xfrm>
              <a:off x="3597255" y="4492325"/>
              <a:ext cx="7310600" cy="2168329"/>
              <a:chOff x="3702359" y="3579238"/>
              <a:chExt cx="7310600" cy="2168329"/>
            </a:xfrm>
          </p:grpSpPr>
          <p:pic>
            <p:nvPicPr>
              <p:cNvPr id="3" name="Picture 2" descr="A white paper with black lines&#10;&#10;Description automatically generated">
                <a:extLst>
                  <a:ext uri="{FF2B5EF4-FFF2-40B4-BE49-F238E27FC236}">
                    <a16:creationId xmlns:a16="http://schemas.microsoft.com/office/drawing/2014/main" id="{D75E41A7-845A-0E3C-DE71-1699BCBF82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742" t="33149" r="7416" b="13812"/>
              <a:stretch/>
            </p:blipFill>
            <p:spPr>
              <a:xfrm>
                <a:off x="3722066" y="3696225"/>
                <a:ext cx="3676370" cy="1009461"/>
              </a:xfrm>
              <a:prstGeom prst="rect">
                <a:avLst/>
              </a:prstGeom>
            </p:spPr>
          </p:pic>
          <p:pic>
            <p:nvPicPr>
              <p:cNvPr id="4" name="Picture 3" descr="A close-up of a white object&#10;&#10;Description automatically generated">
                <a:extLst>
                  <a:ext uri="{FF2B5EF4-FFF2-40B4-BE49-F238E27FC236}">
                    <a16:creationId xmlns:a16="http://schemas.microsoft.com/office/drawing/2014/main" id="{DF00C3AE-BC16-76EB-9C43-74BD644121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717" t="26482" r="8873" b="34387"/>
              <a:stretch/>
            </p:blipFill>
            <p:spPr>
              <a:xfrm>
                <a:off x="7461900" y="3696225"/>
                <a:ext cx="3531986" cy="1004607"/>
              </a:xfrm>
              <a:prstGeom prst="rect">
                <a:avLst/>
              </a:prstGeom>
            </p:spPr>
          </p:pic>
          <p:pic>
            <p:nvPicPr>
              <p:cNvPr id="5" name="Picture 4" descr="A close-up of a grey object&#10;&#10;Description automatically generated">
                <a:extLst>
                  <a:ext uri="{FF2B5EF4-FFF2-40B4-BE49-F238E27FC236}">
                    <a16:creationId xmlns:a16="http://schemas.microsoft.com/office/drawing/2014/main" id="{D1953E50-D559-3842-A300-5DD70A82A9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7302" t="27209" r="6825" b="30873"/>
              <a:stretch/>
            </p:blipFill>
            <p:spPr>
              <a:xfrm>
                <a:off x="7461900" y="4740690"/>
                <a:ext cx="3551059" cy="1006830"/>
              </a:xfrm>
              <a:prstGeom prst="rect">
                <a:avLst/>
              </a:prstGeom>
            </p:spPr>
          </p:pic>
          <p:pic>
            <p:nvPicPr>
              <p:cNvPr id="6" name="Picture 5" descr="A close-up of a rectangular object&#10;&#10;Description automatically generated">
                <a:extLst>
                  <a:ext uri="{FF2B5EF4-FFF2-40B4-BE49-F238E27FC236}">
                    <a16:creationId xmlns:a16="http://schemas.microsoft.com/office/drawing/2014/main" id="{1FAC8D8A-43AF-921A-D683-C7E19A4329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4320" t="33991" r="6240" b="12884"/>
              <a:stretch/>
            </p:blipFill>
            <p:spPr>
              <a:xfrm>
                <a:off x="3702359" y="4740690"/>
                <a:ext cx="3694900" cy="1006087"/>
              </a:xfrm>
              <a:prstGeom prst="rect">
                <a:avLst/>
              </a:prstGeom>
            </p:spPr>
          </p:pic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43BF6C03-6716-6161-265E-A4E041FA54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28878" y="3579238"/>
                <a:ext cx="0" cy="216832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4F97230B-EC44-90F1-3C22-D86D483C38DF}"/>
                  </a:ext>
                </a:extLst>
              </p:cNvPr>
              <p:cNvSpPr/>
              <p:nvPr/>
            </p:nvSpPr>
            <p:spPr>
              <a:xfrm>
                <a:off x="3723622" y="4325210"/>
                <a:ext cx="3670926" cy="339111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A72EACDE-ACEC-6291-B88F-A98BA8F26B0B}"/>
                  </a:ext>
                </a:extLst>
              </p:cNvPr>
              <p:cNvSpPr/>
              <p:nvPr/>
            </p:nvSpPr>
            <p:spPr>
              <a:xfrm>
                <a:off x="7481070" y="4234017"/>
                <a:ext cx="3513269" cy="35881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7CB2F71E-6C84-E1B1-06D7-EDC24F59E09E}"/>
                  </a:ext>
                </a:extLst>
              </p:cNvPr>
              <p:cNvSpPr/>
              <p:nvPr/>
            </p:nvSpPr>
            <p:spPr>
              <a:xfrm>
                <a:off x="3723622" y="5356537"/>
                <a:ext cx="3670926" cy="339111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90BED8DC-2186-3C24-B236-C30B814137D7}"/>
                  </a:ext>
                </a:extLst>
              </p:cNvPr>
              <p:cNvSpPr/>
              <p:nvPr/>
            </p:nvSpPr>
            <p:spPr>
              <a:xfrm>
                <a:off x="7474501" y="5264572"/>
                <a:ext cx="3513269" cy="358819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3D84C51-89AC-4A15-142F-57A4A7287EE9}"/>
              </a:ext>
            </a:extLst>
          </p:cNvPr>
          <p:cNvSpPr txBox="1"/>
          <p:nvPr/>
        </p:nvSpPr>
        <p:spPr>
          <a:xfrm>
            <a:off x="14038" y="0"/>
            <a:ext cx="316847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: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blots depicting representative images used for Figures 5B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ots for PGC-1</a:t>
            </a:r>
            <a:r>
              <a:rPr lang="el-GR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re cut at 75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26405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>
            <a:extLst>
              <a:ext uri="{FF2B5EF4-FFF2-40B4-BE49-F238E27FC236}">
                <a16:creationId xmlns:a16="http://schemas.microsoft.com/office/drawing/2014/main" id="{5D1F6E28-1219-C9EB-E771-06A22E6CB391}"/>
              </a:ext>
            </a:extLst>
          </p:cNvPr>
          <p:cNvGrpSpPr/>
          <p:nvPr/>
        </p:nvGrpSpPr>
        <p:grpSpPr>
          <a:xfrm>
            <a:off x="177798" y="2662395"/>
            <a:ext cx="4379406" cy="2492919"/>
            <a:chOff x="6680718" y="512484"/>
            <a:chExt cx="4379406" cy="2492919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84A86DF-C3CA-0449-BBD4-A5B0FCC893F5}"/>
                </a:ext>
              </a:extLst>
            </p:cNvPr>
            <p:cNvSpPr txBox="1"/>
            <p:nvPr/>
          </p:nvSpPr>
          <p:spPr>
            <a:xfrm>
              <a:off x="6692838" y="2071288"/>
              <a:ext cx="671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F4D4561F-BF4A-259D-6CE6-C90DAFF667B4}"/>
                </a:ext>
              </a:extLst>
            </p:cNvPr>
            <p:cNvCxnSpPr>
              <a:cxnSpLocks/>
            </p:cNvCxnSpPr>
            <p:nvPr/>
          </p:nvCxnSpPr>
          <p:spPr>
            <a:xfrm>
              <a:off x="8743039" y="695340"/>
              <a:ext cx="3385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81C68184-19A3-4FB2-7339-14A66B40EDE2}"/>
                </a:ext>
              </a:extLst>
            </p:cNvPr>
            <p:cNvCxnSpPr>
              <a:cxnSpLocks/>
            </p:cNvCxnSpPr>
            <p:nvPr/>
          </p:nvCxnSpPr>
          <p:spPr>
            <a:xfrm>
              <a:off x="10012977" y="691059"/>
              <a:ext cx="5666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4644B177-268A-8037-D8FB-33697504ECD2}"/>
                </a:ext>
              </a:extLst>
            </p:cNvPr>
            <p:cNvCxnSpPr>
              <a:cxnSpLocks/>
            </p:cNvCxnSpPr>
            <p:nvPr/>
          </p:nvCxnSpPr>
          <p:spPr>
            <a:xfrm>
              <a:off x="8169757" y="692293"/>
              <a:ext cx="44306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19FCA95C-E365-1124-17CB-7B0636B078B6}"/>
                </a:ext>
              </a:extLst>
            </p:cNvPr>
            <p:cNvCxnSpPr>
              <a:cxnSpLocks/>
            </p:cNvCxnSpPr>
            <p:nvPr/>
          </p:nvCxnSpPr>
          <p:spPr>
            <a:xfrm>
              <a:off x="9171844" y="691059"/>
              <a:ext cx="68248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8EAD43B-F0FF-C224-3289-B9DCCB7437B7}"/>
                </a:ext>
              </a:extLst>
            </p:cNvPr>
            <p:cNvSpPr txBox="1"/>
            <p:nvPr/>
          </p:nvSpPr>
          <p:spPr>
            <a:xfrm>
              <a:off x="7281556" y="512484"/>
              <a:ext cx="430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9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04AF9DE-5815-7AF5-7D93-AFFFDBDFE421}"/>
                </a:ext>
              </a:extLst>
            </p:cNvPr>
            <p:cNvSpPr txBox="1"/>
            <p:nvPr/>
          </p:nvSpPr>
          <p:spPr>
            <a:xfrm>
              <a:off x="7239609" y="2067920"/>
              <a:ext cx="4059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AEF606BE-F45A-4374-A2BC-AF8825A4DAAE}"/>
                </a:ext>
              </a:extLst>
            </p:cNvPr>
            <p:cNvCxnSpPr>
              <a:cxnSpLocks/>
            </p:cNvCxnSpPr>
            <p:nvPr/>
          </p:nvCxnSpPr>
          <p:spPr>
            <a:xfrm>
              <a:off x="7497006" y="2189513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518A0FB5-596C-C053-5A67-827D8DE94F85}"/>
                </a:ext>
              </a:extLst>
            </p:cNvPr>
            <p:cNvCxnSpPr>
              <a:cxnSpLocks/>
            </p:cNvCxnSpPr>
            <p:nvPr/>
          </p:nvCxnSpPr>
          <p:spPr>
            <a:xfrm>
              <a:off x="7496964" y="2350816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ED5F4A2-51E6-030D-D4C4-54385361DB7A}"/>
                </a:ext>
              </a:extLst>
            </p:cNvPr>
            <p:cNvSpPr txBox="1"/>
            <p:nvPr/>
          </p:nvSpPr>
          <p:spPr>
            <a:xfrm>
              <a:off x="7242213" y="2224328"/>
              <a:ext cx="3803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227039B-4D2E-D986-2B7F-73969BF3FDAE}"/>
                </a:ext>
              </a:extLst>
            </p:cNvPr>
            <p:cNvSpPr txBox="1"/>
            <p:nvPr/>
          </p:nvSpPr>
          <p:spPr>
            <a:xfrm>
              <a:off x="7243657" y="845106"/>
              <a:ext cx="4059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47C10807-BBF8-12D4-E345-41E05FCFB0F9}"/>
                </a:ext>
              </a:extLst>
            </p:cNvPr>
            <p:cNvCxnSpPr>
              <a:cxnSpLocks/>
            </p:cNvCxnSpPr>
            <p:nvPr/>
          </p:nvCxnSpPr>
          <p:spPr>
            <a:xfrm>
              <a:off x="7494720" y="959299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5712641A-2DE5-842A-56C6-630F54992B7A}"/>
                </a:ext>
              </a:extLst>
            </p:cNvPr>
            <p:cNvCxnSpPr>
              <a:cxnSpLocks/>
            </p:cNvCxnSpPr>
            <p:nvPr/>
          </p:nvCxnSpPr>
          <p:spPr>
            <a:xfrm>
              <a:off x="7498930" y="1120602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6EA4FFC-B7EE-09F4-7693-46C65AEC79A4}"/>
                </a:ext>
              </a:extLst>
            </p:cNvPr>
            <p:cNvSpPr txBox="1"/>
            <p:nvPr/>
          </p:nvSpPr>
          <p:spPr>
            <a:xfrm>
              <a:off x="7241605" y="1000090"/>
              <a:ext cx="3803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96B85EE-DBBB-0827-F10F-2666B78EFF62}"/>
                </a:ext>
              </a:extLst>
            </p:cNvPr>
            <p:cNvSpPr txBox="1"/>
            <p:nvPr/>
          </p:nvSpPr>
          <p:spPr>
            <a:xfrm>
              <a:off x="6680718" y="845516"/>
              <a:ext cx="6719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MnSOD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750254AB-B786-867D-28E6-B716225A0D35}"/>
                </a:ext>
              </a:extLst>
            </p:cNvPr>
            <p:cNvCxnSpPr>
              <a:cxnSpLocks/>
            </p:cNvCxnSpPr>
            <p:nvPr/>
          </p:nvCxnSpPr>
          <p:spPr>
            <a:xfrm>
              <a:off x="7726874" y="693259"/>
              <a:ext cx="32491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B5D3A28-A317-B182-1EE8-7A2E76D6C3A3}"/>
                </a:ext>
              </a:extLst>
            </p:cNvPr>
            <p:cNvSpPr txBox="1"/>
            <p:nvPr/>
          </p:nvSpPr>
          <p:spPr>
            <a:xfrm>
              <a:off x="7604448" y="529482"/>
              <a:ext cx="3455676" cy="215444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800" dirty="0">
                  <a:latin typeface="Arial"/>
                  <a:cs typeface="Arial"/>
                </a:rPr>
                <a:t>MW  LC       RT-F           TN-F            RT-M                  TN-M</a:t>
              </a:r>
            </a:p>
          </p:txBody>
        </p: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86F09B79-E4BB-D3D9-6D79-C53868DA1DAD}"/>
                </a:ext>
              </a:extLst>
            </p:cNvPr>
            <p:cNvGrpSpPr/>
            <p:nvPr/>
          </p:nvGrpSpPr>
          <p:grpSpPr>
            <a:xfrm>
              <a:off x="7567232" y="715180"/>
              <a:ext cx="3269264" cy="2290223"/>
              <a:chOff x="6607310" y="180790"/>
              <a:chExt cx="3269264" cy="2290223"/>
            </a:xfrm>
          </p:grpSpPr>
          <p:pic>
            <p:nvPicPr>
              <p:cNvPr id="10" name="Picture 9" descr="A black line on a white background&#10;&#10;Description automatically generated">
                <a:extLst>
                  <a:ext uri="{FF2B5EF4-FFF2-40B4-BE49-F238E27FC236}">
                    <a16:creationId xmlns:a16="http://schemas.microsoft.com/office/drawing/2014/main" id="{31ACD329-64BC-DC8E-60D8-E8F8E07AAC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9684" t="22222" r="22737" b="17222"/>
              <a:stretch/>
            </p:blipFill>
            <p:spPr>
              <a:xfrm>
                <a:off x="6607310" y="180790"/>
                <a:ext cx="3268963" cy="1116083"/>
              </a:xfrm>
              <a:prstGeom prst="rect">
                <a:avLst/>
              </a:prstGeom>
            </p:spPr>
          </p:pic>
          <p:pic>
            <p:nvPicPr>
              <p:cNvPr id="11" name="Picture 10" descr="A close-up of a piece of paper&#10;&#10;Description automatically generated">
                <a:extLst>
                  <a:ext uri="{FF2B5EF4-FFF2-40B4-BE49-F238E27FC236}">
                    <a16:creationId xmlns:a16="http://schemas.microsoft.com/office/drawing/2014/main" id="{8B42CF08-2E55-BFB5-9834-8C09B7DD26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684" t="18681" r="22737" b="21978"/>
              <a:stretch/>
            </p:blipFill>
            <p:spPr>
              <a:xfrm>
                <a:off x="6607592" y="1355421"/>
                <a:ext cx="3268982" cy="1115592"/>
              </a:xfrm>
              <a:prstGeom prst="rect">
                <a:avLst/>
              </a:prstGeom>
            </p:spPr>
          </p:pic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EECCA34B-4887-E398-2586-E9130A162A24}"/>
                  </a:ext>
                </a:extLst>
              </p:cNvPr>
              <p:cNvSpPr/>
              <p:nvPr/>
            </p:nvSpPr>
            <p:spPr>
              <a:xfrm>
                <a:off x="6679869" y="306779"/>
                <a:ext cx="3048000" cy="435428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Rectangle 65">
                <a:extLst>
                  <a:ext uri="{FF2B5EF4-FFF2-40B4-BE49-F238E27FC236}">
                    <a16:creationId xmlns:a16="http://schemas.microsoft.com/office/drawing/2014/main" id="{939B7915-AFDF-20EA-818A-229B7CE72673}"/>
                  </a:ext>
                </a:extLst>
              </p:cNvPr>
              <p:cNvSpPr/>
              <p:nvPr/>
            </p:nvSpPr>
            <p:spPr>
              <a:xfrm>
                <a:off x="6679869" y="1523999"/>
                <a:ext cx="3048000" cy="435428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B572A7FA-70B8-3405-739A-4D16910B322D}"/>
              </a:ext>
            </a:extLst>
          </p:cNvPr>
          <p:cNvGrpSpPr/>
          <p:nvPr/>
        </p:nvGrpSpPr>
        <p:grpSpPr>
          <a:xfrm>
            <a:off x="5289715" y="2585469"/>
            <a:ext cx="6166259" cy="3320534"/>
            <a:chOff x="427642" y="2998649"/>
            <a:chExt cx="6166259" cy="3320534"/>
          </a:xfrm>
        </p:grpSpPr>
        <p:pic>
          <p:nvPicPr>
            <p:cNvPr id="6" name="Picture 5" descr="A black and white photo of a rectangular object&#10;&#10;Description automatically generated">
              <a:extLst>
                <a:ext uri="{FF2B5EF4-FFF2-40B4-BE49-F238E27FC236}">
                  <a16:creationId xmlns:a16="http://schemas.microsoft.com/office/drawing/2014/main" id="{15CAB283-67E0-B8F4-FE63-22E858146A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587" t="6559" r="4708" b="6532"/>
            <a:stretch/>
          </p:blipFill>
          <p:spPr>
            <a:xfrm>
              <a:off x="3843348" y="4678436"/>
              <a:ext cx="2515628" cy="1469214"/>
            </a:xfrm>
            <a:prstGeom prst="rect">
              <a:avLst/>
            </a:prstGeom>
          </p:spPr>
        </p:pic>
        <p:pic>
          <p:nvPicPr>
            <p:cNvPr id="7" name="Picture 6" descr="A close up of a white sheet&#10;&#10;Description automatically generated">
              <a:extLst>
                <a:ext uri="{FF2B5EF4-FFF2-40B4-BE49-F238E27FC236}">
                  <a16:creationId xmlns:a16="http://schemas.microsoft.com/office/drawing/2014/main" id="{E9084594-2280-8C94-8DC1-346BEE9726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385" t="7427" r="2726" b="9549"/>
            <a:stretch/>
          </p:blipFill>
          <p:spPr>
            <a:xfrm>
              <a:off x="3846496" y="3251399"/>
              <a:ext cx="2514170" cy="1462864"/>
            </a:xfrm>
            <a:prstGeom prst="rect">
              <a:avLst/>
            </a:prstGeom>
          </p:spPr>
        </p:pic>
        <p:pic>
          <p:nvPicPr>
            <p:cNvPr id="8" name="Picture 7" descr="A close-up of a grey rectangular object&#10;&#10;Description automatically generated">
              <a:extLst>
                <a:ext uri="{FF2B5EF4-FFF2-40B4-BE49-F238E27FC236}">
                  <a16:creationId xmlns:a16="http://schemas.microsoft.com/office/drawing/2014/main" id="{55586FBF-1FF2-A0C9-DBD4-635D9F7898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698" t="9894" r="4698" b="9541"/>
            <a:stretch/>
          </p:blipFill>
          <p:spPr>
            <a:xfrm>
              <a:off x="1333286" y="4747832"/>
              <a:ext cx="2485471" cy="1396289"/>
            </a:xfrm>
            <a:prstGeom prst="rect">
              <a:avLst/>
            </a:prstGeom>
          </p:spPr>
        </p:pic>
        <p:pic>
          <p:nvPicPr>
            <p:cNvPr id="9" name="Picture 8" descr="A close-up of a white sheet&#10;&#10;Description automatically generated">
              <a:extLst>
                <a:ext uri="{FF2B5EF4-FFF2-40B4-BE49-F238E27FC236}">
                  <a16:creationId xmlns:a16="http://schemas.microsoft.com/office/drawing/2014/main" id="{E4AE69A8-A54E-0E02-1706-0341D368D6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381" t="9059" r="4036" b="11150"/>
            <a:stretch/>
          </p:blipFill>
          <p:spPr>
            <a:xfrm>
              <a:off x="1333287" y="3275387"/>
              <a:ext cx="2484877" cy="1404074"/>
            </a:xfrm>
            <a:prstGeom prst="rect">
              <a:avLst/>
            </a:prstGeom>
          </p:spPr>
        </p:pic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6677AC99-3CA7-5756-4457-B16F9D233A09}"/>
                </a:ext>
              </a:extLst>
            </p:cNvPr>
            <p:cNvSpPr txBox="1"/>
            <p:nvPr/>
          </p:nvSpPr>
          <p:spPr>
            <a:xfrm>
              <a:off x="1256037" y="3103856"/>
              <a:ext cx="2785534" cy="184666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MW LC          RT-M                   TN-M                       RT-M            TN-M</a:t>
              </a:r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0F1AAF1C-220C-73E4-9386-0D1BC3B0AAC6}"/>
                </a:ext>
              </a:extLst>
            </p:cNvPr>
            <p:cNvCxnSpPr>
              <a:cxnSpLocks/>
            </p:cNvCxnSpPr>
            <p:nvPr/>
          </p:nvCxnSpPr>
          <p:spPr>
            <a:xfrm>
              <a:off x="3494169" y="3249484"/>
              <a:ext cx="2835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7802BED8-C583-B23E-2265-D49F3D0E54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02204" y="3251184"/>
              <a:ext cx="51994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893D4406-5ABD-62E0-531A-D2B551180D2A}"/>
                </a:ext>
              </a:extLst>
            </p:cNvPr>
            <p:cNvCxnSpPr>
              <a:cxnSpLocks/>
            </p:cNvCxnSpPr>
            <p:nvPr/>
          </p:nvCxnSpPr>
          <p:spPr>
            <a:xfrm>
              <a:off x="1644270" y="3249880"/>
              <a:ext cx="50592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E909918D-0DAD-D292-DB31-5475A2FCCAE7}"/>
                </a:ext>
              </a:extLst>
            </p:cNvPr>
            <p:cNvCxnSpPr>
              <a:cxnSpLocks/>
            </p:cNvCxnSpPr>
            <p:nvPr/>
          </p:nvCxnSpPr>
          <p:spPr>
            <a:xfrm>
              <a:off x="2252851" y="3251176"/>
              <a:ext cx="54595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D199F3F3-AD6F-5A3F-8BFF-CB99044B8F98}"/>
                </a:ext>
              </a:extLst>
            </p:cNvPr>
            <p:cNvSpPr txBox="1"/>
            <p:nvPr/>
          </p:nvSpPr>
          <p:spPr>
            <a:xfrm>
              <a:off x="1010532" y="3103288"/>
              <a:ext cx="430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9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E25A0104-9087-3934-DB68-6BE87CCFD2E7}"/>
                </a:ext>
              </a:extLst>
            </p:cNvPr>
            <p:cNvSpPr txBox="1"/>
            <p:nvPr/>
          </p:nvSpPr>
          <p:spPr>
            <a:xfrm>
              <a:off x="3778189" y="3101721"/>
              <a:ext cx="2815712" cy="184666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MW LC          RT-F                  TN-F               RT-F                     TN-F           </a:t>
              </a:r>
              <a:endParaRPr lang="en-US" sz="6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C9B6336E-9AFD-DE57-934E-2E2591961F52}"/>
                </a:ext>
              </a:extLst>
            </p:cNvPr>
            <p:cNvCxnSpPr>
              <a:cxnSpLocks/>
            </p:cNvCxnSpPr>
            <p:nvPr/>
          </p:nvCxnSpPr>
          <p:spPr>
            <a:xfrm>
              <a:off x="4198741" y="3249654"/>
              <a:ext cx="47697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8279ED48-39A3-396D-8245-D84CB5764C2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68185" y="3243945"/>
              <a:ext cx="404704" cy="103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108751CE-7C7B-AAB8-4CA9-1571A45687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44678" y="3243952"/>
              <a:ext cx="498503" cy="16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31B46347-2797-E8D6-CFB3-48D9BDEE11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45222" y="3243948"/>
              <a:ext cx="48106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84AA82BC-59D9-759F-2639-FFF393AFEC4C}"/>
                </a:ext>
              </a:extLst>
            </p:cNvPr>
            <p:cNvCxnSpPr>
              <a:cxnSpLocks/>
            </p:cNvCxnSpPr>
            <p:nvPr/>
          </p:nvCxnSpPr>
          <p:spPr>
            <a:xfrm>
              <a:off x="1353549" y="3251176"/>
              <a:ext cx="22742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E50808C4-E0AE-E0B2-A45F-DF399F7452A0}"/>
                </a:ext>
              </a:extLst>
            </p:cNvPr>
            <p:cNvCxnSpPr>
              <a:cxnSpLocks/>
            </p:cNvCxnSpPr>
            <p:nvPr/>
          </p:nvCxnSpPr>
          <p:spPr>
            <a:xfrm>
              <a:off x="3885958" y="3252479"/>
              <a:ext cx="20873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A289A3AE-D3D9-0A6C-C1F3-8D09D5A6852A}"/>
                </a:ext>
              </a:extLst>
            </p:cNvPr>
            <p:cNvSpPr/>
            <p:nvPr/>
          </p:nvSpPr>
          <p:spPr>
            <a:xfrm>
              <a:off x="1355766" y="4225636"/>
              <a:ext cx="2444337" cy="247402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0771AE14-5EEA-EC92-41DE-C275A4E21E62}"/>
                </a:ext>
              </a:extLst>
            </p:cNvPr>
            <p:cNvSpPr/>
            <p:nvPr/>
          </p:nvSpPr>
          <p:spPr>
            <a:xfrm>
              <a:off x="1355765" y="5680363"/>
              <a:ext cx="2444337" cy="247402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848D9C1E-361B-D232-94D0-19AFDC8E100F}"/>
                </a:ext>
              </a:extLst>
            </p:cNvPr>
            <p:cNvSpPr/>
            <p:nvPr/>
          </p:nvSpPr>
          <p:spPr>
            <a:xfrm>
              <a:off x="3844910" y="4225635"/>
              <a:ext cx="2514701" cy="247402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8DC97890-98FB-AF60-2B87-1E6F1FAC39E8}"/>
                </a:ext>
              </a:extLst>
            </p:cNvPr>
            <p:cNvSpPr/>
            <p:nvPr/>
          </p:nvSpPr>
          <p:spPr>
            <a:xfrm>
              <a:off x="3855349" y="5680362"/>
              <a:ext cx="2493817" cy="227610"/>
            </a:xfrm>
            <a:prstGeom prst="rect">
              <a:avLst/>
            </a:prstGeom>
            <a:noFill/>
            <a:ln w="28575"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F423AF6B-A0AE-4421-AA86-95625C24DDC8}"/>
                </a:ext>
              </a:extLst>
            </p:cNvPr>
            <p:cNvSpPr txBox="1"/>
            <p:nvPr/>
          </p:nvSpPr>
          <p:spPr>
            <a:xfrm>
              <a:off x="1011986" y="4204913"/>
              <a:ext cx="4059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C9E8018A-B557-E720-582E-1C97C0446DE9}"/>
                </a:ext>
              </a:extLst>
            </p:cNvPr>
            <p:cNvCxnSpPr>
              <a:cxnSpLocks/>
            </p:cNvCxnSpPr>
            <p:nvPr/>
          </p:nvCxnSpPr>
          <p:spPr>
            <a:xfrm>
              <a:off x="1254487" y="4319106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4A21D170-99A0-5ACA-B70A-22F474C9EADF}"/>
                </a:ext>
              </a:extLst>
            </p:cNvPr>
            <p:cNvCxnSpPr>
              <a:cxnSpLocks/>
            </p:cNvCxnSpPr>
            <p:nvPr/>
          </p:nvCxnSpPr>
          <p:spPr>
            <a:xfrm>
              <a:off x="1254417" y="4416195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8040B281-C164-5880-52E8-EF495305E547}"/>
                </a:ext>
              </a:extLst>
            </p:cNvPr>
            <p:cNvSpPr txBox="1"/>
            <p:nvPr/>
          </p:nvSpPr>
          <p:spPr>
            <a:xfrm>
              <a:off x="1009934" y="4317088"/>
              <a:ext cx="3803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20DB1F1B-2833-4D36-5D97-F1F2D57BAFA3}"/>
                </a:ext>
              </a:extLst>
            </p:cNvPr>
            <p:cNvSpPr txBox="1"/>
            <p:nvPr/>
          </p:nvSpPr>
          <p:spPr>
            <a:xfrm>
              <a:off x="427642" y="4226728"/>
              <a:ext cx="6719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MnSOD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A09C3388-7F19-7579-6327-53433D7F5C23}"/>
                </a:ext>
              </a:extLst>
            </p:cNvPr>
            <p:cNvSpPr txBox="1"/>
            <p:nvPr/>
          </p:nvSpPr>
          <p:spPr>
            <a:xfrm>
              <a:off x="449658" y="5627406"/>
              <a:ext cx="6291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84F469E7-9931-3F7F-D9FA-4793E13DEA42}"/>
                </a:ext>
              </a:extLst>
            </p:cNvPr>
            <p:cNvSpPr txBox="1"/>
            <p:nvPr/>
          </p:nvSpPr>
          <p:spPr>
            <a:xfrm>
              <a:off x="996430" y="5628318"/>
              <a:ext cx="4059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441FAE4B-9D17-4027-6593-E86FFB9AA015}"/>
                </a:ext>
              </a:extLst>
            </p:cNvPr>
            <p:cNvCxnSpPr>
              <a:cxnSpLocks/>
            </p:cNvCxnSpPr>
            <p:nvPr/>
          </p:nvCxnSpPr>
          <p:spPr>
            <a:xfrm>
              <a:off x="1253826" y="5762754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553BFC74-E01C-CD03-27F7-7FFAD71B1C8E}"/>
                </a:ext>
              </a:extLst>
            </p:cNvPr>
            <p:cNvCxnSpPr>
              <a:cxnSpLocks/>
            </p:cNvCxnSpPr>
            <p:nvPr/>
          </p:nvCxnSpPr>
          <p:spPr>
            <a:xfrm>
              <a:off x="1253784" y="5868405"/>
              <a:ext cx="7128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8E69A053-7285-1772-0B28-F7DC264C714E}"/>
                </a:ext>
              </a:extLst>
            </p:cNvPr>
            <p:cNvSpPr txBox="1"/>
            <p:nvPr/>
          </p:nvSpPr>
          <p:spPr>
            <a:xfrm>
              <a:off x="994751" y="5763321"/>
              <a:ext cx="3204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7E3C24AD-4191-B129-26DE-3A6CE83772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27356" y="2998649"/>
              <a:ext cx="14952" cy="332053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D6915134-E710-0589-B4AC-8F16EC6B93AF}"/>
              </a:ext>
            </a:extLst>
          </p:cNvPr>
          <p:cNvSpPr txBox="1"/>
          <p:nvPr/>
        </p:nvSpPr>
        <p:spPr>
          <a:xfrm>
            <a:off x="983411" y="1864640"/>
            <a:ext cx="39596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6A: PVAT whole blot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8E2EA13-0BC3-13D2-AA5A-CC68AAE82D3C}"/>
              </a:ext>
            </a:extLst>
          </p:cNvPr>
          <p:cNvSpPr txBox="1"/>
          <p:nvPr/>
        </p:nvSpPr>
        <p:spPr>
          <a:xfrm>
            <a:off x="6107468" y="1862032"/>
            <a:ext cx="5638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6B: aorta whole blot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2AA1BEE-DA2A-E268-2BA2-48F5943F3334}"/>
              </a:ext>
            </a:extLst>
          </p:cNvPr>
          <p:cNvSpPr txBox="1"/>
          <p:nvPr/>
        </p:nvSpPr>
        <p:spPr>
          <a:xfrm>
            <a:off x="-4824" y="5613"/>
            <a:ext cx="119926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5: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blots depicting representative images used for Figures 5B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ots for PVAT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nSO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re cut at 37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739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Tk5MS42MDAwMDAwMDAwMDAxfDc3NDgyNS8xNTMyL0VudHJ5UGFydC8xNjY1NDc2NzY4fDUwNTUuNTk5OTk5OTk5OTk5</eid>
  <version>1</version>
  <updated-at>2023-10-06T16:42:26Z</updated-at>
</LabArchives>
</file>

<file path=customXml/itemProps1.xml><?xml version="1.0" encoding="utf-8"?>
<ds:datastoreItem xmlns:ds="http://schemas.openxmlformats.org/officeDocument/2006/customXml" ds:itemID="{B22C6F8B-6EE7-4DF9-AA75-4FD2F3308FD0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17</TotalTime>
  <Words>360</Words>
  <Application>Microsoft Office PowerPoint</Application>
  <PresentationFormat>Widescreen</PresentationFormat>
  <Paragraphs>127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er, Amy</dc:creator>
  <cp:lastModifiedBy>Keller, Amy</cp:lastModifiedBy>
  <cp:revision>1596</cp:revision>
  <dcterms:created xsi:type="dcterms:W3CDTF">2023-05-01T14:12:35Z</dcterms:created>
  <dcterms:modified xsi:type="dcterms:W3CDTF">2024-05-09T15:01:48Z</dcterms:modified>
</cp:coreProperties>
</file>